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6227763" cy="6858000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淡色スタイル 1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47" autoAdjust="0"/>
    <p:restoredTop sz="89018" autoAdjust="0"/>
  </p:normalViewPr>
  <p:slideViewPr>
    <p:cSldViewPr snapToGrid="0">
      <p:cViewPr varScale="1">
        <p:scale>
          <a:sx n="96" d="100"/>
          <a:sy n="96" d="100"/>
        </p:scale>
        <p:origin x="13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勇治 箱崎" userId="9db2de78f3965622" providerId="LiveId" clId="{5B2AEB1F-E50E-4C48-88E2-849225976E96}"/>
    <pc:docChg chg="undo custSel delSld modSld sldOrd">
      <pc:chgData name="勇治 箱崎" userId="9db2de78f3965622" providerId="LiveId" clId="{5B2AEB1F-E50E-4C48-88E2-849225976E96}" dt="2024-02-10T07:56:36.345" v="3759" actId="1038"/>
      <pc:docMkLst>
        <pc:docMk/>
      </pc:docMkLst>
      <pc:sldChg chg="addSp delSp modSp mod">
        <pc:chgData name="勇治 箱崎" userId="9db2de78f3965622" providerId="LiveId" clId="{5B2AEB1F-E50E-4C48-88E2-849225976E96}" dt="2024-02-10T05:39:20.186" v="708" actId="20577"/>
        <pc:sldMkLst>
          <pc:docMk/>
          <pc:sldMk cId="3562092320" sldId="262"/>
        </pc:sldMkLst>
        <pc:spChg chg="add del mod">
          <ac:chgData name="勇治 箱崎" userId="9db2de78f3965622" providerId="LiveId" clId="{5B2AEB1F-E50E-4C48-88E2-849225976E96}" dt="2024-02-10T05:32:12.681" v="497" actId="478"/>
          <ac:spMkLst>
            <pc:docMk/>
            <pc:sldMk cId="3562092320" sldId="262"/>
            <ac:spMk id="3" creationId="{6C1749B5-86DA-58D6-287A-98300A621E15}"/>
          </ac:spMkLst>
        </pc:spChg>
        <pc:spChg chg="add del mod">
          <ac:chgData name="勇治 箱崎" userId="9db2de78f3965622" providerId="LiveId" clId="{5B2AEB1F-E50E-4C48-88E2-849225976E96}" dt="2024-02-10T05:32:04.098" v="494" actId="478"/>
          <ac:spMkLst>
            <pc:docMk/>
            <pc:sldMk cId="3562092320" sldId="262"/>
            <ac:spMk id="4" creationId="{29A75A4A-6C37-0C69-BFDA-45B43F73BBBF}"/>
          </ac:spMkLst>
        </pc:spChg>
        <pc:spChg chg="add del mod">
          <ac:chgData name="勇治 箱崎" userId="9db2de78f3965622" providerId="LiveId" clId="{5B2AEB1F-E50E-4C48-88E2-849225976E96}" dt="2024-02-10T05:32:08.880" v="495" actId="478"/>
          <ac:spMkLst>
            <pc:docMk/>
            <pc:sldMk cId="3562092320" sldId="262"/>
            <ac:spMk id="5" creationId="{11E305D2-EB9B-786A-E196-66732589BE1E}"/>
          </ac:spMkLst>
        </pc:spChg>
        <pc:spChg chg="add del mod">
          <ac:chgData name="勇治 箱崎" userId="9db2de78f3965622" providerId="LiveId" clId="{5B2AEB1F-E50E-4C48-88E2-849225976E96}" dt="2024-02-10T05:32:16.981" v="499" actId="478"/>
          <ac:spMkLst>
            <pc:docMk/>
            <pc:sldMk cId="3562092320" sldId="262"/>
            <ac:spMk id="6" creationId="{5753802A-6FC6-32B1-FD61-965EE851AD53}"/>
          </ac:spMkLst>
        </pc:spChg>
        <pc:spChg chg="add del mod">
          <ac:chgData name="勇治 箱崎" userId="9db2de78f3965622" providerId="LiveId" clId="{5B2AEB1F-E50E-4C48-88E2-849225976E96}" dt="2024-02-10T05:32:24.181" v="501" actId="478"/>
          <ac:spMkLst>
            <pc:docMk/>
            <pc:sldMk cId="3562092320" sldId="262"/>
            <ac:spMk id="7" creationId="{3DF6410E-7892-1E99-5B69-9F301B93578C}"/>
          </ac:spMkLst>
        </pc:spChg>
        <pc:spChg chg="del">
          <ac:chgData name="勇治 箱崎" userId="9db2de78f3965622" providerId="LiveId" clId="{5B2AEB1F-E50E-4C48-88E2-849225976E96}" dt="2024-02-10T05:34:16.092" v="517" actId="478"/>
          <ac:spMkLst>
            <pc:docMk/>
            <pc:sldMk cId="3562092320" sldId="262"/>
            <ac:spMk id="10" creationId="{BF324EF5-1C21-0BA7-16B7-698FC158BDA0}"/>
          </ac:spMkLst>
        </pc:spChg>
        <pc:spChg chg="add del mod">
          <ac:chgData name="勇治 箱崎" userId="9db2de78f3965622" providerId="LiveId" clId="{5B2AEB1F-E50E-4C48-88E2-849225976E96}" dt="2024-02-10T05:32:24.973" v="502" actId="478"/>
          <ac:spMkLst>
            <pc:docMk/>
            <pc:sldMk cId="3562092320" sldId="262"/>
            <ac:spMk id="11" creationId="{496F0E13-B4B9-21DB-015C-2AFEB5FA6669}"/>
          </ac:spMkLst>
        </pc:spChg>
        <pc:spChg chg="add del mod">
          <ac:chgData name="勇治 箱崎" userId="9db2de78f3965622" providerId="LiveId" clId="{5B2AEB1F-E50E-4C48-88E2-849225976E96}" dt="2024-02-10T05:32:02.567" v="493" actId="478"/>
          <ac:spMkLst>
            <pc:docMk/>
            <pc:sldMk cId="3562092320" sldId="262"/>
            <ac:spMk id="12" creationId="{3A7E3A24-A288-E8EF-FB90-87F01CC6B135}"/>
          </ac:spMkLst>
        </pc:spChg>
        <pc:spChg chg="add del mod">
          <ac:chgData name="勇治 箱崎" userId="9db2de78f3965622" providerId="LiveId" clId="{5B2AEB1F-E50E-4C48-88E2-849225976E96}" dt="2024-02-10T05:32:00.525" v="492" actId="478"/>
          <ac:spMkLst>
            <pc:docMk/>
            <pc:sldMk cId="3562092320" sldId="262"/>
            <ac:spMk id="13" creationId="{43456156-10AB-4664-411E-5FCA308E66B8}"/>
          </ac:spMkLst>
        </pc:spChg>
        <pc:spChg chg="del">
          <ac:chgData name="勇治 箱崎" userId="9db2de78f3965622" providerId="LiveId" clId="{5B2AEB1F-E50E-4C48-88E2-849225976E96}" dt="2024-02-10T05:34:16.092" v="517" actId="478"/>
          <ac:spMkLst>
            <pc:docMk/>
            <pc:sldMk cId="3562092320" sldId="262"/>
            <ac:spMk id="14" creationId="{906CFAA3-0316-D73F-26CD-1C56BB349F66}"/>
          </ac:spMkLst>
        </pc:spChg>
        <pc:spChg chg="mod">
          <ac:chgData name="勇治 箱崎" userId="9db2de78f3965622" providerId="LiveId" clId="{5B2AEB1F-E50E-4C48-88E2-849225976E96}" dt="2024-02-10T05:34:48.886" v="542" actId="1036"/>
          <ac:spMkLst>
            <pc:docMk/>
            <pc:sldMk cId="3562092320" sldId="262"/>
            <ac:spMk id="15" creationId="{39D79EFF-E0C8-5F72-F4E9-99B7B4F49411}"/>
          </ac:spMkLst>
        </pc:spChg>
        <pc:spChg chg="mod">
          <ac:chgData name="勇治 箱崎" userId="9db2de78f3965622" providerId="LiveId" clId="{5B2AEB1F-E50E-4C48-88E2-849225976E96}" dt="2024-02-10T05:38:04.604" v="672" actId="1037"/>
          <ac:spMkLst>
            <pc:docMk/>
            <pc:sldMk cId="3562092320" sldId="262"/>
            <ac:spMk id="16" creationId="{49D0D77D-CAD7-AD31-CEBF-1E5CAE179E2E}"/>
          </ac:spMkLst>
        </pc:spChg>
        <pc:spChg chg="mod">
          <ac:chgData name="勇治 箱崎" userId="9db2de78f3965622" providerId="LiveId" clId="{5B2AEB1F-E50E-4C48-88E2-849225976E96}" dt="2024-02-10T05:37:27.961" v="647" actId="404"/>
          <ac:spMkLst>
            <pc:docMk/>
            <pc:sldMk cId="3562092320" sldId="262"/>
            <ac:spMk id="17" creationId="{123EDEFD-1F22-B3C8-56D3-EC522ED7C0DF}"/>
          </ac:spMkLst>
        </pc:spChg>
        <pc:spChg chg="mod">
          <ac:chgData name="勇治 箱崎" userId="9db2de78f3965622" providerId="LiveId" clId="{5B2AEB1F-E50E-4C48-88E2-849225976E96}" dt="2024-02-10T05:39:20.186" v="708" actId="20577"/>
          <ac:spMkLst>
            <pc:docMk/>
            <pc:sldMk cId="3562092320" sldId="262"/>
            <ac:spMk id="18" creationId="{767E14A0-3081-225B-46AE-2D46F49D3F9D}"/>
          </ac:spMkLst>
        </pc:spChg>
        <pc:spChg chg="mod">
          <ac:chgData name="勇治 箱崎" userId="9db2de78f3965622" providerId="LiveId" clId="{5B2AEB1F-E50E-4C48-88E2-849225976E96}" dt="2024-02-10T05:37:42.139" v="649" actId="1076"/>
          <ac:spMkLst>
            <pc:docMk/>
            <pc:sldMk cId="3562092320" sldId="262"/>
            <ac:spMk id="19" creationId="{F7BA1F15-8EE1-F6AA-51F9-7742C5DE516C}"/>
          </ac:spMkLst>
        </pc:spChg>
        <pc:spChg chg="mod">
          <ac:chgData name="勇治 箱崎" userId="9db2de78f3965622" providerId="LiveId" clId="{5B2AEB1F-E50E-4C48-88E2-849225976E96}" dt="2024-02-10T05:34:42.341" v="536" actId="1076"/>
          <ac:spMkLst>
            <pc:docMk/>
            <pc:sldMk cId="3562092320" sldId="262"/>
            <ac:spMk id="20" creationId="{E190522B-7977-B9A2-8FDC-73987CCFAA02}"/>
          </ac:spMkLst>
        </pc:spChg>
        <pc:spChg chg="mod">
          <ac:chgData name="勇治 箱崎" userId="9db2de78f3965622" providerId="LiveId" clId="{5B2AEB1F-E50E-4C48-88E2-849225976E96}" dt="2024-02-10T05:34:42.341" v="536" actId="1076"/>
          <ac:spMkLst>
            <pc:docMk/>
            <pc:sldMk cId="3562092320" sldId="262"/>
            <ac:spMk id="21" creationId="{EC06F1E5-E098-F697-961A-2A227293717B}"/>
          </ac:spMkLst>
        </pc:spChg>
        <pc:spChg chg="mod">
          <ac:chgData name="勇治 箱崎" userId="9db2de78f3965622" providerId="LiveId" clId="{5B2AEB1F-E50E-4C48-88E2-849225976E96}" dt="2024-02-10T05:34:42.341" v="536" actId="1076"/>
          <ac:spMkLst>
            <pc:docMk/>
            <pc:sldMk cId="3562092320" sldId="262"/>
            <ac:spMk id="22" creationId="{601F2CA9-49EB-FB46-3B36-1B96317D37A7}"/>
          </ac:spMkLst>
        </pc:spChg>
        <pc:spChg chg="add del mod">
          <ac:chgData name="勇治 箱崎" userId="9db2de78f3965622" providerId="LiveId" clId="{5B2AEB1F-E50E-4C48-88E2-849225976E96}" dt="2024-02-10T05:32:22.658" v="500" actId="478"/>
          <ac:spMkLst>
            <pc:docMk/>
            <pc:sldMk cId="3562092320" sldId="262"/>
            <ac:spMk id="23" creationId="{48EE2707-DFBC-FF67-C4E2-F5D51AD95D1B}"/>
          </ac:spMkLst>
        </pc:spChg>
        <pc:spChg chg="add del mod">
          <ac:chgData name="勇治 箱崎" userId="9db2de78f3965622" providerId="LiveId" clId="{5B2AEB1F-E50E-4C48-88E2-849225976E96}" dt="2024-02-10T05:32:26.306" v="503" actId="478"/>
          <ac:spMkLst>
            <pc:docMk/>
            <pc:sldMk cId="3562092320" sldId="262"/>
            <ac:spMk id="24" creationId="{B5FD7ED9-80E6-BF19-46D8-0F7713CD46D8}"/>
          </ac:spMkLst>
        </pc:spChg>
        <pc:spChg chg="add mod">
          <ac:chgData name="勇治 箱崎" userId="9db2de78f3965622" providerId="LiveId" clId="{5B2AEB1F-E50E-4C48-88E2-849225976E96}" dt="2024-02-10T05:34:27.660" v="533" actId="1036"/>
          <ac:spMkLst>
            <pc:docMk/>
            <pc:sldMk cId="3562092320" sldId="262"/>
            <ac:spMk id="27" creationId="{3D3F27C5-25B4-1C0B-B696-80A2F41BBE58}"/>
          </ac:spMkLst>
        </pc:spChg>
        <pc:spChg chg="add mod">
          <ac:chgData name="勇治 箱崎" userId="9db2de78f3965622" providerId="LiveId" clId="{5B2AEB1F-E50E-4C48-88E2-849225976E96}" dt="2024-02-10T05:34:27.660" v="533" actId="1036"/>
          <ac:spMkLst>
            <pc:docMk/>
            <pc:sldMk cId="3562092320" sldId="262"/>
            <ac:spMk id="28" creationId="{7279A104-5970-2E95-DA69-3183E3EF4B25}"/>
          </ac:spMkLst>
        </pc:spChg>
        <pc:picChg chg="add del mod">
          <ac:chgData name="勇治 箱崎" userId="9db2de78f3965622" providerId="LiveId" clId="{5B2AEB1F-E50E-4C48-88E2-849225976E96}" dt="2024-02-10T05:31:59.325" v="491" actId="478"/>
          <ac:picMkLst>
            <pc:docMk/>
            <pc:sldMk cId="3562092320" sldId="262"/>
            <ac:picMk id="2" creationId="{88B93D99-FA0E-A318-97E1-DE763C3AE858}"/>
          </ac:picMkLst>
        </pc:picChg>
        <pc:picChg chg="del">
          <ac:chgData name="勇治 箱崎" userId="9db2de78f3965622" providerId="LiveId" clId="{5B2AEB1F-E50E-4C48-88E2-849225976E96}" dt="2024-02-10T05:34:18.980" v="519" actId="478"/>
          <ac:picMkLst>
            <pc:docMk/>
            <pc:sldMk cId="3562092320" sldId="262"/>
            <ac:picMk id="9" creationId="{E59A0EDD-A348-DFA0-C6C6-FEC971F10835}"/>
          </ac:picMkLst>
        </pc:picChg>
        <pc:picChg chg="add mod ord modCrop">
          <ac:chgData name="勇治 箱崎" userId="9db2de78f3965622" providerId="LiveId" clId="{5B2AEB1F-E50E-4C48-88E2-849225976E96}" dt="2024-02-10T05:35:49.910" v="561" actId="1037"/>
          <ac:picMkLst>
            <pc:docMk/>
            <pc:sldMk cId="3562092320" sldId="262"/>
            <ac:picMk id="26" creationId="{42885834-F224-BB31-7875-093674B06E49}"/>
          </ac:picMkLst>
        </pc:picChg>
      </pc:sldChg>
      <pc:sldChg chg="del">
        <pc:chgData name="勇治 箱崎" userId="9db2de78f3965622" providerId="LiveId" clId="{5B2AEB1F-E50E-4C48-88E2-849225976E96}" dt="2024-02-10T07:47:08.741" v="3699" actId="47"/>
        <pc:sldMkLst>
          <pc:docMk/>
          <pc:sldMk cId="1408471767" sldId="280"/>
        </pc:sldMkLst>
      </pc:sldChg>
      <pc:sldChg chg="modSp mod">
        <pc:chgData name="勇治 箱崎" userId="9db2de78f3965622" providerId="LiveId" clId="{5B2AEB1F-E50E-4C48-88E2-849225976E96}" dt="2024-02-10T07:49:19.782" v="3708" actId="1038"/>
        <pc:sldMkLst>
          <pc:docMk/>
          <pc:sldMk cId="3973636590" sldId="288"/>
        </pc:sldMkLst>
        <pc:spChg chg="mod">
          <ac:chgData name="勇治 箱崎" userId="9db2de78f3965622" providerId="LiveId" clId="{5B2AEB1F-E50E-4C48-88E2-849225976E96}" dt="2024-02-10T07:49:19.782" v="3708" actId="1038"/>
          <ac:spMkLst>
            <pc:docMk/>
            <pc:sldMk cId="3973636590" sldId="288"/>
            <ac:spMk id="12" creationId="{3DD7D0EB-1D6D-415F-7B44-67E1DF7C7A48}"/>
          </ac:spMkLst>
        </pc:spChg>
        <pc:spChg chg="mod">
          <ac:chgData name="勇治 箱崎" userId="9db2de78f3965622" providerId="LiveId" clId="{5B2AEB1F-E50E-4C48-88E2-849225976E96}" dt="2024-02-10T07:49:19.782" v="3708" actId="1038"/>
          <ac:spMkLst>
            <pc:docMk/>
            <pc:sldMk cId="3973636590" sldId="288"/>
            <ac:spMk id="14" creationId="{2EAA1D48-4EEE-78F9-1348-AADFB917CA77}"/>
          </ac:spMkLst>
        </pc:spChg>
        <pc:picChg chg="mod">
          <ac:chgData name="勇治 箱崎" userId="9db2de78f3965622" providerId="LiveId" clId="{5B2AEB1F-E50E-4C48-88E2-849225976E96}" dt="2024-02-10T07:49:19.782" v="3708" actId="1038"/>
          <ac:picMkLst>
            <pc:docMk/>
            <pc:sldMk cId="3973636590" sldId="288"/>
            <ac:picMk id="5" creationId="{7D6CBC77-527E-D4CD-F617-F1DC08DDCC5E}"/>
          </ac:picMkLst>
        </pc:picChg>
        <pc:picChg chg="mod">
          <ac:chgData name="勇治 箱崎" userId="9db2de78f3965622" providerId="LiveId" clId="{5B2AEB1F-E50E-4C48-88E2-849225976E96}" dt="2024-02-10T07:49:19.782" v="3708" actId="1038"/>
          <ac:picMkLst>
            <pc:docMk/>
            <pc:sldMk cId="3973636590" sldId="288"/>
            <ac:picMk id="6" creationId="{8313CA5E-7EA0-FF6E-1861-1163DCC8722E}"/>
          </ac:picMkLst>
        </pc:picChg>
      </pc:sldChg>
      <pc:sldChg chg="del">
        <pc:chgData name="勇治 箱崎" userId="9db2de78f3965622" providerId="LiveId" clId="{5B2AEB1F-E50E-4C48-88E2-849225976E96}" dt="2024-02-10T06:57:03.842" v="1690" actId="47"/>
        <pc:sldMkLst>
          <pc:docMk/>
          <pc:sldMk cId="215150484" sldId="289"/>
        </pc:sldMkLst>
      </pc:sldChg>
      <pc:sldChg chg="addSp delSp modSp mod ord">
        <pc:chgData name="勇治 箱崎" userId="9db2de78f3965622" providerId="LiveId" clId="{5B2AEB1F-E50E-4C48-88E2-849225976E96}" dt="2024-02-10T07:56:36.345" v="3759" actId="1038"/>
        <pc:sldMkLst>
          <pc:docMk/>
          <pc:sldMk cId="294657801" sldId="290"/>
        </pc:sldMkLst>
        <pc:spChg chg="mod">
          <ac:chgData name="勇治 箱崎" userId="9db2de78f3965622" providerId="LiveId" clId="{5B2AEB1F-E50E-4C48-88E2-849225976E96}" dt="2024-02-10T07:18:42.672" v="2432" actId="1076"/>
          <ac:spMkLst>
            <pc:docMk/>
            <pc:sldMk cId="294657801" sldId="290"/>
            <ac:spMk id="2" creationId="{86FF0DC3-F5CD-DAD9-662F-8464229C601C}"/>
          </ac:spMkLst>
        </pc:spChg>
        <pc:spChg chg="del mod">
          <ac:chgData name="勇治 箱崎" userId="9db2de78f3965622" providerId="LiveId" clId="{5B2AEB1F-E50E-4C48-88E2-849225976E96}" dt="2024-02-10T06:58:08.044" v="1823" actId="478"/>
          <ac:spMkLst>
            <pc:docMk/>
            <pc:sldMk cId="294657801" sldId="290"/>
            <ac:spMk id="3" creationId="{A7DA6A70-841D-E158-C0C9-502B5DD74E03}"/>
          </ac:spMkLst>
        </pc:spChg>
        <pc:spChg chg="del mod">
          <ac:chgData name="勇治 箱崎" userId="9db2de78f3965622" providerId="LiveId" clId="{5B2AEB1F-E50E-4C48-88E2-849225976E96}" dt="2024-02-10T07:29:38.044" v="2899" actId="478"/>
          <ac:spMkLst>
            <pc:docMk/>
            <pc:sldMk cId="294657801" sldId="290"/>
            <ac:spMk id="6" creationId="{F2C39037-E8E4-76B8-1D8F-7C849C00CC6A}"/>
          </ac:spMkLst>
        </pc:spChg>
        <pc:spChg chg="del mod">
          <ac:chgData name="勇治 箱崎" userId="9db2de78f3965622" providerId="LiveId" clId="{5B2AEB1F-E50E-4C48-88E2-849225976E96}" dt="2024-02-10T07:29:38.044" v="2899" actId="478"/>
          <ac:spMkLst>
            <pc:docMk/>
            <pc:sldMk cId="294657801" sldId="290"/>
            <ac:spMk id="7" creationId="{650F9978-8FF1-2162-0A64-029692E61DB7}"/>
          </ac:spMkLst>
        </pc:spChg>
        <pc:spChg chg="del mod">
          <ac:chgData name="勇治 箱崎" userId="9db2de78f3965622" providerId="LiveId" clId="{5B2AEB1F-E50E-4C48-88E2-849225976E96}" dt="2024-02-10T07:41:29.003" v="3381" actId="478"/>
          <ac:spMkLst>
            <pc:docMk/>
            <pc:sldMk cId="294657801" sldId="290"/>
            <ac:spMk id="8" creationId="{474B71DF-AD45-1781-3BC7-ED96FB0E86D4}"/>
          </ac:spMkLst>
        </pc:spChg>
        <pc:spChg chg="mod">
          <ac:chgData name="勇治 箱崎" userId="9db2de78f3965622" providerId="LiveId" clId="{5B2AEB1F-E50E-4C48-88E2-849225976E96}" dt="2024-02-10T07:38:50.062" v="3157" actId="404"/>
          <ac:spMkLst>
            <pc:docMk/>
            <pc:sldMk cId="294657801" sldId="290"/>
            <ac:spMk id="9" creationId="{AB409D32-AFCC-2BF0-2504-176F8C92E3CC}"/>
          </ac:spMkLst>
        </pc:spChg>
        <pc:spChg chg="del mod">
          <ac:chgData name="勇治 箱崎" userId="9db2de78f3965622" providerId="LiveId" clId="{5B2AEB1F-E50E-4C48-88E2-849225976E96}" dt="2024-02-10T07:41:26.374" v="3380" actId="478"/>
          <ac:spMkLst>
            <pc:docMk/>
            <pc:sldMk cId="294657801" sldId="290"/>
            <ac:spMk id="11" creationId="{F95875DC-17E6-7348-54FE-FCD76045ABF5}"/>
          </ac:spMkLst>
        </pc:spChg>
        <pc:spChg chg="del mod">
          <ac:chgData name="勇治 箱崎" userId="9db2de78f3965622" providerId="LiveId" clId="{5B2AEB1F-E50E-4C48-88E2-849225976E96}" dt="2024-02-10T07:41:29.003" v="3381" actId="478"/>
          <ac:spMkLst>
            <pc:docMk/>
            <pc:sldMk cId="294657801" sldId="290"/>
            <ac:spMk id="12" creationId="{BF051B17-95EC-4AD6-9E77-BD01AB48C537}"/>
          </ac:spMkLst>
        </pc:spChg>
        <pc:spChg chg="mod">
          <ac:chgData name="勇治 箱崎" userId="9db2de78f3965622" providerId="LiveId" clId="{5B2AEB1F-E50E-4C48-88E2-849225976E96}" dt="2024-02-10T06:57:30.310" v="1698" actId="1036"/>
          <ac:spMkLst>
            <pc:docMk/>
            <pc:sldMk cId="294657801" sldId="290"/>
            <ac:spMk id="13" creationId="{913104A6-9D4E-E56A-C555-1206BFA1E727}"/>
          </ac:spMkLst>
        </pc:spChg>
        <pc:spChg chg="mod">
          <ac:chgData name="勇治 箱崎" userId="9db2de78f3965622" providerId="LiveId" clId="{5B2AEB1F-E50E-4C48-88E2-849225976E96}" dt="2024-02-10T07:18:57.696" v="2453" actId="1037"/>
          <ac:spMkLst>
            <pc:docMk/>
            <pc:sldMk cId="294657801" sldId="290"/>
            <ac:spMk id="14" creationId="{CCBCE029-48CC-0913-E81C-C09C0B61D6A8}"/>
          </ac:spMkLst>
        </pc:spChg>
        <pc:spChg chg="mod">
          <ac:chgData name="勇治 箱崎" userId="9db2de78f3965622" providerId="LiveId" clId="{5B2AEB1F-E50E-4C48-88E2-849225976E96}" dt="2024-02-10T07:14:58.890" v="2225" actId="1036"/>
          <ac:spMkLst>
            <pc:docMk/>
            <pc:sldMk cId="294657801" sldId="290"/>
            <ac:spMk id="15" creationId="{590D5EF0-A407-927C-2077-A49A5D45CEA1}"/>
          </ac:spMkLst>
        </pc:spChg>
        <pc:spChg chg="mod">
          <ac:chgData name="勇治 箱崎" userId="9db2de78f3965622" providerId="LiveId" clId="{5B2AEB1F-E50E-4C48-88E2-849225976E96}" dt="2024-02-10T07:04:17.146" v="1979" actId="1076"/>
          <ac:spMkLst>
            <pc:docMk/>
            <pc:sldMk cId="294657801" sldId="290"/>
            <ac:spMk id="16" creationId="{73B04260-396A-9AE9-3BD7-6FA130D902FA}"/>
          </ac:spMkLst>
        </pc:spChg>
        <pc:spChg chg="mod">
          <ac:chgData name="勇治 箱崎" userId="9db2de78f3965622" providerId="LiveId" clId="{5B2AEB1F-E50E-4C48-88E2-849225976E96}" dt="2024-02-10T07:05:50.112" v="2051" actId="1076"/>
          <ac:spMkLst>
            <pc:docMk/>
            <pc:sldMk cId="294657801" sldId="290"/>
            <ac:spMk id="17" creationId="{C0A540F2-6C2C-2EAB-7616-385C79141BFB}"/>
          </ac:spMkLst>
        </pc:spChg>
        <pc:spChg chg="del mod">
          <ac:chgData name="勇治 箱崎" userId="9db2de78f3965622" providerId="LiveId" clId="{5B2AEB1F-E50E-4C48-88E2-849225976E96}" dt="2024-02-10T07:17:54.574" v="2429" actId="478"/>
          <ac:spMkLst>
            <pc:docMk/>
            <pc:sldMk cId="294657801" sldId="290"/>
            <ac:spMk id="18" creationId="{6D9F363F-D067-606D-AA55-D5AD1284A41E}"/>
          </ac:spMkLst>
        </pc:spChg>
        <pc:spChg chg="del mod">
          <ac:chgData name="勇治 箱崎" userId="9db2de78f3965622" providerId="LiveId" clId="{5B2AEB1F-E50E-4C48-88E2-849225976E96}" dt="2024-02-10T07:17:55.514" v="2430" actId="478"/>
          <ac:spMkLst>
            <pc:docMk/>
            <pc:sldMk cId="294657801" sldId="290"/>
            <ac:spMk id="19" creationId="{0C4D7AEB-3FFF-D0CF-C15F-C95821B27C8C}"/>
          </ac:spMkLst>
        </pc:spChg>
        <pc:spChg chg="del mod">
          <ac:chgData name="勇治 箱崎" userId="9db2de78f3965622" providerId="LiveId" clId="{5B2AEB1F-E50E-4C48-88E2-849225976E96}" dt="2024-02-10T07:17:52.131" v="2428" actId="478"/>
          <ac:spMkLst>
            <pc:docMk/>
            <pc:sldMk cId="294657801" sldId="290"/>
            <ac:spMk id="20" creationId="{6A390629-700F-F765-CC9B-D41510FD1684}"/>
          </ac:spMkLst>
        </pc:spChg>
        <pc:spChg chg="del mod">
          <ac:chgData name="勇治 箱崎" userId="9db2de78f3965622" providerId="LiveId" clId="{5B2AEB1F-E50E-4C48-88E2-849225976E96}" dt="2024-02-10T07:17:56.345" v="2431" actId="478"/>
          <ac:spMkLst>
            <pc:docMk/>
            <pc:sldMk cId="294657801" sldId="290"/>
            <ac:spMk id="21" creationId="{1FF60D09-159D-48B3-45E1-BD8DB6D39972}"/>
          </ac:spMkLst>
        </pc:spChg>
        <pc:spChg chg="mo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22" creationId="{551DE481-3CB3-8BCB-4649-45B863E8CDBD}"/>
          </ac:spMkLst>
        </pc:spChg>
        <pc:spChg chg="mo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23" creationId="{36D565C9-4937-F633-7646-A66348BB5651}"/>
          </ac:spMkLst>
        </pc:spChg>
        <pc:spChg chg="mo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24" creationId="{5EE92BB0-D2FE-0E58-6CDA-FD3AD15D7625}"/>
          </ac:spMkLst>
        </pc:spChg>
        <pc:spChg chg="del mod">
          <ac:chgData name="勇治 箱崎" userId="9db2de78f3965622" providerId="LiveId" clId="{5B2AEB1F-E50E-4C48-88E2-849225976E96}" dt="2024-02-10T07:36:41.716" v="3085" actId="478"/>
          <ac:spMkLst>
            <pc:docMk/>
            <pc:sldMk cId="294657801" sldId="290"/>
            <ac:spMk id="25" creationId="{25EAF5D6-1998-560E-6D20-DC3A905FC035}"/>
          </ac:spMkLst>
        </pc:spChg>
        <pc:spChg chg="del mod">
          <ac:chgData name="勇治 箱崎" userId="9db2de78f3965622" providerId="LiveId" clId="{5B2AEB1F-E50E-4C48-88E2-849225976E96}" dt="2024-02-10T07:36:40.962" v="3084" actId="478"/>
          <ac:spMkLst>
            <pc:docMk/>
            <pc:sldMk cId="294657801" sldId="290"/>
            <ac:spMk id="26" creationId="{0931F3D8-2601-3667-AA5D-45F79901B82E}"/>
          </ac:spMkLst>
        </pc:spChg>
        <pc:spChg chg="del mod">
          <ac:chgData name="勇治 箱崎" userId="9db2de78f3965622" providerId="LiveId" clId="{5B2AEB1F-E50E-4C48-88E2-849225976E96}" dt="2024-02-10T07:36:48.717" v="3089" actId="478"/>
          <ac:spMkLst>
            <pc:docMk/>
            <pc:sldMk cId="294657801" sldId="290"/>
            <ac:spMk id="27" creationId="{2AFD3D17-CBE5-EC84-0123-DFA513A54915}"/>
          </ac:spMkLst>
        </pc:spChg>
        <pc:spChg chg="del mod">
          <ac:chgData name="勇治 箱崎" userId="9db2de78f3965622" providerId="LiveId" clId="{5B2AEB1F-E50E-4C48-88E2-849225976E96}" dt="2024-02-10T07:42:27.517" v="3517" actId="478"/>
          <ac:spMkLst>
            <pc:docMk/>
            <pc:sldMk cId="294657801" sldId="290"/>
            <ac:spMk id="28" creationId="{CDB76F11-B377-C460-C651-640E6AED541D}"/>
          </ac:spMkLst>
        </pc:spChg>
        <pc:spChg chg="del mod">
          <ac:chgData name="勇治 箱崎" userId="9db2de78f3965622" providerId="LiveId" clId="{5B2AEB1F-E50E-4C48-88E2-849225976E96}" dt="2024-02-10T06:58:41.535" v="1950" actId="478"/>
          <ac:spMkLst>
            <pc:docMk/>
            <pc:sldMk cId="294657801" sldId="290"/>
            <ac:spMk id="29" creationId="{E5A2CCE9-CAE1-088D-5983-E353D3FC591B}"/>
          </ac:spMkLst>
        </pc:spChg>
        <pc:spChg chg="del mod">
          <ac:chgData name="勇治 箱崎" userId="9db2de78f3965622" providerId="LiveId" clId="{5B2AEB1F-E50E-4C48-88E2-849225976E96}" dt="2024-02-10T07:36:14.024" v="3079"/>
          <ac:spMkLst>
            <pc:docMk/>
            <pc:sldMk cId="294657801" sldId="290"/>
            <ac:spMk id="30" creationId="{638749BC-9FE0-7D97-D578-4432B5E4F343}"/>
          </ac:spMkLst>
        </pc:spChg>
        <pc:spChg chg="add mod">
          <ac:chgData name="勇治 箱崎" userId="9db2de78f3965622" providerId="LiveId" clId="{5B2AEB1F-E50E-4C48-88E2-849225976E96}" dt="2024-02-10T07:17:48.938" v="2427" actId="20577"/>
          <ac:spMkLst>
            <pc:docMk/>
            <pc:sldMk cId="294657801" sldId="290"/>
            <ac:spMk id="32" creationId="{D56A596D-76F1-9244-6355-45FBFA99BC45}"/>
          </ac:spMkLst>
        </pc:spChg>
        <pc:spChg chg="del mod">
          <ac:chgData name="勇治 箱崎" userId="9db2de78f3965622" providerId="LiveId" clId="{5B2AEB1F-E50E-4C48-88E2-849225976E96}" dt="2024-02-10T06:58:39.430" v="1948" actId="478"/>
          <ac:spMkLst>
            <pc:docMk/>
            <pc:sldMk cId="294657801" sldId="290"/>
            <ac:spMk id="33" creationId="{7DE7C953-4ED1-6E13-0617-9213CAA34A80}"/>
          </ac:spMkLst>
        </pc:spChg>
        <pc:spChg chg="del mod">
          <ac:chgData name="勇治 箱崎" userId="9db2de78f3965622" providerId="LiveId" clId="{5B2AEB1F-E50E-4C48-88E2-849225976E96}" dt="2024-02-10T07:29:38.044" v="2899" actId="478"/>
          <ac:spMkLst>
            <pc:docMk/>
            <pc:sldMk cId="294657801" sldId="290"/>
            <ac:spMk id="34" creationId="{8B0736EE-DD37-05E7-675B-36CE54299405}"/>
          </ac:spMkLst>
        </pc:spChg>
        <pc:spChg chg="del mod">
          <ac:chgData name="勇治 箱崎" userId="9db2de78f3965622" providerId="LiveId" clId="{5B2AEB1F-E50E-4C48-88E2-849225976E96}" dt="2024-02-10T07:29:38.044" v="2899" actId="478"/>
          <ac:spMkLst>
            <pc:docMk/>
            <pc:sldMk cId="294657801" sldId="290"/>
            <ac:spMk id="35" creationId="{3787C5F6-CED6-B5A7-65F5-07163ED24831}"/>
          </ac:spMkLst>
        </pc:spChg>
        <pc:spChg chg="del mod">
          <ac:chgData name="勇治 箱崎" userId="9db2de78f3965622" providerId="LiveId" clId="{5B2AEB1F-E50E-4C48-88E2-849225976E96}" dt="2024-02-10T07:41:47.089" v="3385" actId="478"/>
          <ac:spMkLst>
            <pc:docMk/>
            <pc:sldMk cId="294657801" sldId="290"/>
            <ac:spMk id="36" creationId="{398390F9-8C67-67FF-DD38-6C5E5392FD1E}"/>
          </ac:spMkLst>
        </pc:spChg>
        <pc:spChg chg="del mod">
          <ac:chgData name="勇治 箱崎" userId="9db2de78f3965622" providerId="LiveId" clId="{5B2AEB1F-E50E-4C48-88E2-849225976E96}" dt="2024-02-10T07:22:08.259" v="2638" actId="478"/>
          <ac:spMkLst>
            <pc:docMk/>
            <pc:sldMk cId="294657801" sldId="290"/>
            <ac:spMk id="37" creationId="{41B79AAF-C8AB-4642-E8CF-60606DB4DFD8}"/>
          </ac:spMkLst>
        </pc:spChg>
        <pc:spChg chg="del mod">
          <ac:chgData name="勇治 箱崎" userId="9db2de78f3965622" providerId="LiveId" clId="{5B2AEB1F-E50E-4C48-88E2-849225976E96}" dt="2024-02-10T07:22:15.911" v="2639" actId="478"/>
          <ac:spMkLst>
            <pc:docMk/>
            <pc:sldMk cId="294657801" sldId="290"/>
            <ac:spMk id="38" creationId="{B3CD02F5-6E6E-144D-8266-0802917261AA}"/>
          </ac:spMkLst>
        </pc:spChg>
        <pc:spChg chg="del mod">
          <ac:chgData name="勇治 箱崎" userId="9db2de78f3965622" providerId="LiveId" clId="{5B2AEB1F-E50E-4C48-88E2-849225976E96}" dt="2024-02-10T07:22:22.392" v="2640" actId="478"/>
          <ac:spMkLst>
            <pc:docMk/>
            <pc:sldMk cId="294657801" sldId="290"/>
            <ac:spMk id="39" creationId="{7735D847-C9CA-C156-1DE8-5703846B8FB9}"/>
          </ac:spMkLst>
        </pc:spChg>
        <pc:spChg chg="del mod">
          <ac:chgData name="勇治 箱崎" userId="9db2de78f3965622" providerId="LiveId" clId="{5B2AEB1F-E50E-4C48-88E2-849225976E96}" dt="2024-02-10T07:22:58.968" v="2665" actId="478"/>
          <ac:spMkLst>
            <pc:docMk/>
            <pc:sldMk cId="294657801" sldId="290"/>
            <ac:spMk id="40" creationId="{4B79C42A-C075-AFE6-9947-C42D3ACF4794}"/>
          </ac:spMkLst>
        </pc:spChg>
        <pc:spChg chg="del mod">
          <ac:chgData name="勇治 箱崎" userId="9db2de78f3965622" providerId="LiveId" clId="{5B2AEB1F-E50E-4C48-88E2-849225976E96}" dt="2024-02-10T07:28:53.287" v="2895" actId="478"/>
          <ac:spMkLst>
            <pc:docMk/>
            <pc:sldMk cId="294657801" sldId="290"/>
            <ac:spMk id="41" creationId="{E7B378A6-E308-67D6-AD01-01C5DAAA2136}"/>
          </ac:spMkLst>
        </pc:spChg>
        <pc:spChg chg="del mod">
          <ac:chgData name="勇治 箱崎" userId="9db2de78f3965622" providerId="LiveId" clId="{5B2AEB1F-E50E-4C48-88E2-849225976E96}" dt="2024-02-10T07:27:38.636" v="2829" actId="478"/>
          <ac:spMkLst>
            <pc:docMk/>
            <pc:sldMk cId="294657801" sldId="290"/>
            <ac:spMk id="42" creationId="{5BF6944A-1905-7750-415F-84106F24EC7F}"/>
          </ac:spMkLst>
        </pc:spChg>
        <pc:spChg chg="del mod">
          <ac:chgData name="勇治 箱崎" userId="9db2de78f3965622" providerId="LiveId" clId="{5B2AEB1F-E50E-4C48-88E2-849225976E96}" dt="2024-02-10T07:28:53.287" v="2895" actId="478"/>
          <ac:spMkLst>
            <pc:docMk/>
            <pc:sldMk cId="294657801" sldId="290"/>
            <ac:spMk id="43" creationId="{97BBB116-8309-0C2E-9799-D03ECA376EDA}"/>
          </ac:spMkLst>
        </pc:spChg>
        <pc:spChg chg="del mod">
          <ac:chgData name="勇治 箱崎" userId="9db2de78f3965622" providerId="LiveId" clId="{5B2AEB1F-E50E-4C48-88E2-849225976E96}" dt="2024-02-10T07:28:53.287" v="2895" actId="478"/>
          <ac:spMkLst>
            <pc:docMk/>
            <pc:sldMk cId="294657801" sldId="290"/>
            <ac:spMk id="44" creationId="{F0967A57-DC14-5665-34ED-D8DC4AE3F7C6}"/>
          </ac:spMkLst>
        </pc:spChg>
        <pc:spChg chg="del mod">
          <ac:chgData name="勇治 箱崎" userId="9db2de78f3965622" providerId="LiveId" clId="{5B2AEB1F-E50E-4C48-88E2-849225976E96}" dt="2024-02-10T07:22:49.184" v="2657" actId="478"/>
          <ac:spMkLst>
            <pc:docMk/>
            <pc:sldMk cId="294657801" sldId="290"/>
            <ac:spMk id="45" creationId="{D2018BC8-EAFB-C63D-3AC3-50B1D3AD975A}"/>
          </ac:spMkLst>
        </pc:spChg>
        <pc:spChg chg="del mod">
          <ac:chgData name="勇治 箱崎" userId="9db2de78f3965622" providerId="LiveId" clId="{5B2AEB1F-E50E-4C48-88E2-849225976E96}" dt="2024-02-10T07:22:46.450" v="2656" actId="478"/>
          <ac:spMkLst>
            <pc:docMk/>
            <pc:sldMk cId="294657801" sldId="290"/>
            <ac:spMk id="46" creationId="{8F4A9DDE-EA3C-AE0A-1B15-176C5F2C8239}"/>
          </ac:spMkLst>
        </pc:spChg>
        <pc:spChg chg="del mod">
          <ac:chgData name="勇治 箱崎" userId="9db2de78f3965622" providerId="LiveId" clId="{5B2AEB1F-E50E-4C48-88E2-849225976E96}" dt="2024-02-10T07:22:49.184" v="2657" actId="478"/>
          <ac:spMkLst>
            <pc:docMk/>
            <pc:sldMk cId="294657801" sldId="290"/>
            <ac:spMk id="47" creationId="{CA931083-F3CD-7472-CE77-EA95A23A19B0}"/>
          </ac:spMkLst>
        </pc:spChg>
        <pc:spChg chg="del mod">
          <ac:chgData name="勇治 箱崎" userId="9db2de78f3965622" providerId="LiveId" clId="{5B2AEB1F-E50E-4C48-88E2-849225976E96}" dt="2024-02-10T07:41:47.089" v="3385" actId="478"/>
          <ac:spMkLst>
            <pc:docMk/>
            <pc:sldMk cId="294657801" sldId="290"/>
            <ac:spMk id="48" creationId="{6A1C5595-6DE4-F835-4ECE-D2C7DF3196C4}"/>
          </ac:spMkLst>
        </pc:spChg>
        <pc:spChg chg="del mod">
          <ac:chgData name="勇治 箱崎" userId="9db2de78f3965622" providerId="LiveId" clId="{5B2AEB1F-E50E-4C48-88E2-849225976E96}" dt="2024-02-10T07:45:52.118" v="3692" actId="478"/>
          <ac:spMkLst>
            <pc:docMk/>
            <pc:sldMk cId="294657801" sldId="290"/>
            <ac:spMk id="50" creationId="{7855581C-220D-CAFA-1803-D8088C6E13A2}"/>
          </ac:spMkLst>
        </pc:spChg>
        <pc:spChg chg="add mod">
          <ac:chgData name="勇治 箱崎" userId="9db2de78f3965622" providerId="LiveId" clId="{5B2AEB1F-E50E-4C48-88E2-849225976E96}" dt="2024-02-10T07:05:45.262" v="2050" actId="1036"/>
          <ac:spMkLst>
            <pc:docMk/>
            <pc:sldMk cId="294657801" sldId="290"/>
            <ac:spMk id="51" creationId="{1B9235E6-DF15-955B-AA03-A3D0C7AAF821}"/>
          </ac:spMkLst>
        </pc:spChg>
        <pc:spChg chg="del mod">
          <ac:chgData name="勇治 箱崎" userId="9db2de78f3965622" providerId="LiveId" clId="{5B2AEB1F-E50E-4C48-88E2-849225976E96}" dt="2024-02-10T07:41:47.089" v="3385" actId="478"/>
          <ac:spMkLst>
            <pc:docMk/>
            <pc:sldMk cId="294657801" sldId="290"/>
            <ac:spMk id="52" creationId="{FF1CA8A0-180B-9850-5E5C-A8A55D7674E2}"/>
          </ac:spMkLst>
        </pc:spChg>
        <pc:spChg chg="add mod">
          <ac:chgData name="勇治 箱崎" userId="9db2de78f3965622" providerId="LiveId" clId="{5B2AEB1F-E50E-4C48-88E2-849225976E96}" dt="2024-02-10T07:05:05.407" v="2015" actId="1038"/>
          <ac:spMkLst>
            <pc:docMk/>
            <pc:sldMk cId="294657801" sldId="290"/>
            <ac:spMk id="53" creationId="{54C85261-DA49-AF74-96ED-C4017C11AE37}"/>
          </ac:spMkLst>
        </pc:spChg>
        <pc:spChg chg="del mod">
          <ac:chgData name="勇治 箱崎" userId="9db2de78f3965622" providerId="LiveId" clId="{5B2AEB1F-E50E-4C48-88E2-849225976E96}" dt="2024-02-10T07:36:51.755" v="3091" actId="478"/>
          <ac:spMkLst>
            <pc:docMk/>
            <pc:sldMk cId="294657801" sldId="290"/>
            <ac:spMk id="54" creationId="{89092AF6-717E-4C38-668F-1D71D79B277C}"/>
          </ac:spMkLst>
        </pc:spChg>
        <pc:spChg chg="del mod">
          <ac:chgData name="勇治 箱崎" userId="9db2de78f3965622" providerId="LiveId" clId="{5B2AEB1F-E50E-4C48-88E2-849225976E96}" dt="2024-02-10T07:36:50.790" v="3090" actId="478"/>
          <ac:spMkLst>
            <pc:docMk/>
            <pc:sldMk cId="294657801" sldId="290"/>
            <ac:spMk id="55" creationId="{935C26F8-173C-A9A4-2C20-32D366448B68}"/>
          </ac:spMkLst>
        </pc:spChg>
        <pc:spChg chg="del mod">
          <ac:chgData name="勇治 箱崎" userId="9db2de78f3965622" providerId="LiveId" clId="{5B2AEB1F-E50E-4C48-88E2-849225976E96}" dt="2024-02-10T07:36:51.755" v="3091" actId="478"/>
          <ac:spMkLst>
            <pc:docMk/>
            <pc:sldMk cId="294657801" sldId="290"/>
            <ac:spMk id="56" creationId="{FBBFCFBC-A659-7045-B7C9-D3CF26CB6B1C}"/>
          </ac:spMkLst>
        </pc:spChg>
        <pc:spChg chg="del mod">
          <ac:chgData name="勇治 箱崎" userId="9db2de78f3965622" providerId="LiveId" clId="{5B2AEB1F-E50E-4C48-88E2-849225976E96}" dt="2024-02-10T07:41:40.560" v="3384" actId="478"/>
          <ac:spMkLst>
            <pc:docMk/>
            <pc:sldMk cId="294657801" sldId="290"/>
            <ac:spMk id="57" creationId="{B52251F3-C396-5CDA-1490-5FDEE377C5C0}"/>
          </ac:spMkLst>
        </pc:spChg>
        <pc:spChg chg="del mod">
          <ac:chgData name="勇治 箱崎" userId="9db2de78f3965622" providerId="LiveId" clId="{5B2AEB1F-E50E-4C48-88E2-849225976E96}" dt="2024-02-10T07:42:55.647" v="3547"/>
          <ac:spMkLst>
            <pc:docMk/>
            <pc:sldMk cId="294657801" sldId="290"/>
            <ac:spMk id="58" creationId="{FB37D917-53C2-891B-A0A8-4E1F73D7C6EE}"/>
          </ac:spMkLst>
        </pc:spChg>
        <pc:spChg chg="add mod">
          <ac:chgData name="勇治 箱崎" userId="9db2de78f3965622" providerId="LiveId" clId="{5B2AEB1F-E50E-4C48-88E2-849225976E96}" dt="2024-02-10T07:12:05.342" v="2155" actId="20577"/>
          <ac:spMkLst>
            <pc:docMk/>
            <pc:sldMk cId="294657801" sldId="290"/>
            <ac:spMk id="59" creationId="{AD3EA5E0-A788-2A7C-B75E-BE24149C9E6C}"/>
          </ac:spMkLst>
        </pc:spChg>
        <pc:spChg chg="mod">
          <ac:chgData name="勇治 箱崎" userId="9db2de78f3965622" providerId="LiveId" clId="{5B2AEB1F-E50E-4C48-88E2-849225976E96}" dt="2024-02-10T07:11:05.556" v="2136" actId="1035"/>
          <ac:spMkLst>
            <pc:docMk/>
            <pc:sldMk cId="294657801" sldId="290"/>
            <ac:spMk id="60" creationId="{A90B06C2-2593-2058-DBEA-246200BF130C}"/>
          </ac:spMkLst>
        </pc:spChg>
        <pc:spChg chg="mod">
          <ac:chgData name="勇治 箱崎" userId="9db2de78f3965622" providerId="LiveId" clId="{5B2AEB1F-E50E-4C48-88E2-849225976E96}" dt="2024-02-10T07:23:16.854" v="2773" actId="1038"/>
          <ac:spMkLst>
            <pc:docMk/>
            <pc:sldMk cId="294657801" sldId="290"/>
            <ac:spMk id="61" creationId="{F2EC3E5C-2900-B894-CAEB-48DD611FED3D}"/>
          </ac:spMkLst>
        </pc:spChg>
        <pc:spChg chg="del mod">
          <ac:chgData name="勇治 箱崎" userId="9db2de78f3965622" providerId="LiveId" clId="{5B2AEB1F-E50E-4C48-88E2-849225976E96}" dt="2024-02-10T07:35:56.733" v="3074" actId="478"/>
          <ac:spMkLst>
            <pc:docMk/>
            <pc:sldMk cId="294657801" sldId="290"/>
            <ac:spMk id="62" creationId="{3A9B0792-B51B-58E0-C37B-45E3DA6775EC}"/>
          </ac:spMkLst>
        </pc:spChg>
        <pc:spChg chg="mod">
          <ac:chgData name="勇治 箱崎" userId="9db2de78f3965622" providerId="LiveId" clId="{5B2AEB1F-E50E-4C48-88E2-849225976E96}" dt="2024-02-10T07:43:56.956" v="3575" actId="1076"/>
          <ac:spMkLst>
            <pc:docMk/>
            <pc:sldMk cId="294657801" sldId="290"/>
            <ac:spMk id="63" creationId="{CF0F3FB1-E4F0-B037-7EA0-573581806BC6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72" creationId="{CED37E4E-5F8E-6433-F39B-2D14383D1CFC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73" creationId="{B31FF346-AB90-1FB2-9C9A-224C77598718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74" creationId="{27D13081-3500-C73D-4A21-550B894B1939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75" creationId="{06D50793-910B-A150-CD5D-7FD793E47B37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76" creationId="{DC39646C-5D22-FD9E-22D6-E5702A5D7A57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77" creationId="{EF0D4941-98E6-B6A5-FD52-E353462AD5D9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78" creationId="{8834A404-70F8-F431-7971-C6FA5A91AD5C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79" creationId="{E5323C0D-53AF-9D9B-7352-E8916C5651E9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80" creationId="{0E3D9BC7-4D02-3C89-75C9-C42F2B710602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81" creationId="{754A3EC4-DA03-D55A-2CD1-1B6F795D9F24}"/>
          </ac:spMkLst>
        </pc:spChg>
        <pc:spChg chg="add mod">
          <ac:chgData name="勇治 箱崎" userId="9db2de78f3965622" providerId="LiveId" clId="{5B2AEB1F-E50E-4C48-88E2-849225976E96}" dt="2024-02-10T07:21:42.265" v="2495"/>
          <ac:spMkLst>
            <pc:docMk/>
            <pc:sldMk cId="294657801" sldId="290"/>
            <ac:spMk id="82" creationId="{65C7C449-224D-E1DE-CB47-FD522138DE3D}"/>
          </ac:spMkLst>
        </pc:spChg>
        <pc:spChg chg="add mod">
          <ac:chgData name="勇治 箱崎" userId="9db2de78f3965622" providerId="LiveId" clId="{5B2AEB1F-E50E-4C48-88E2-849225976E96}" dt="2024-02-10T07:22:05.398" v="2637" actId="20577"/>
          <ac:spMkLst>
            <pc:docMk/>
            <pc:sldMk cId="294657801" sldId="290"/>
            <ac:spMk id="83" creationId="{956F9FB2-280E-0864-4B71-660DB03C03A7}"/>
          </ac:spMkLst>
        </pc:spChg>
        <pc:spChg chg="add mod">
          <ac:chgData name="勇治 箱崎" userId="9db2de78f3965622" providerId="LiveId" clId="{5B2AEB1F-E50E-4C48-88E2-849225976E96}" dt="2024-02-10T07:22:01.498" v="2635" actId="1038"/>
          <ac:spMkLst>
            <pc:docMk/>
            <pc:sldMk cId="294657801" sldId="290"/>
            <ac:spMk id="84" creationId="{CF044607-B947-D27E-3FD2-DE0A1A8B47F2}"/>
          </ac:spMkLst>
        </pc:spChg>
        <pc:spChg chg="add mod">
          <ac:chgData name="勇治 箱崎" userId="9db2de78f3965622" providerId="LiveId" clId="{5B2AEB1F-E50E-4C48-88E2-849225976E96}" dt="2024-02-10T07:22:01.498" v="2635" actId="1038"/>
          <ac:spMkLst>
            <pc:docMk/>
            <pc:sldMk cId="294657801" sldId="290"/>
            <ac:spMk id="85" creationId="{C2650E62-671E-20AD-00D3-43642B893F16}"/>
          </ac:spMkLst>
        </pc:spChg>
        <pc:spChg chg="add mod">
          <ac:chgData name="勇治 箱崎" userId="9db2de78f3965622" providerId="LiveId" clId="{5B2AEB1F-E50E-4C48-88E2-849225976E96}" dt="2024-02-10T07:22:56.693" v="2664" actId="207"/>
          <ac:spMkLst>
            <pc:docMk/>
            <pc:sldMk cId="294657801" sldId="290"/>
            <ac:spMk id="86" creationId="{A64B2302-862A-184E-9121-5A1818DC9243}"/>
          </ac:spMkLst>
        </pc:spChg>
        <pc:spChg chg="add mo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87" creationId="{F82324D2-BFC5-C389-7812-5FB2BD352024}"/>
          </ac:spMkLst>
        </pc:spChg>
        <pc:spChg chg="add mo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88" creationId="{28619982-5BFD-5477-9C12-56230B87B925}"/>
          </ac:spMkLst>
        </pc:spChg>
        <pc:spChg chg="add mo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89" creationId="{F284EDFB-D46F-8A2F-6DBC-0A7630F88E07}"/>
          </ac:spMkLst>
        </pc:spChg>
        <pc:spChg chg="add del mod">
          <ac:chgData name="勇治 箱崎" userId="9db2de78f3965622" providerId="LiveId" clId="{5B2AEB1F-E50E-4C48-88E2-849225976E96}" dt="2024-02-10T07:22:37.138" v="2654" actId="478"/>
          <ac:spMkLst>
            <pc:docMk/>
            <pc:sldMk cId="294657801" sldId="290"/>
            <ac:spMk id="90" creationId="{88D064F4-2F3C-8079-87E4-EC093948A8F6}"/>
          </ac:spMkLst>
        </pc:spChg>
        <pc:spChg chg="add mod">
          <ac:chgData name="勇治 箱崎" userId="9db2de78f3965622" providerId="LiveId" clId="{5B2AEB1F-E50E-4C48-88E2-849225976E96}" dt="2024-02-10T07:28:49.746" v="2894" actId="20577"/>
          <ac:spMkLst>
            <pc:docMk/>
            <pc:sldMk cId="294657801" sldId="290"/>
            <ac:spMk id="91" creationId="{97023520-FD51-602C-7BA9-CBE4B670028F}"/>
          </ac:spMkLst>
        </pc:spChg>
        <pc:spChg chg="add mod">
          <ac:chgData name="勇治 箱崎" userId="9db2de78f3965622" providerId="LiveId" clId="{5B2AEB1F-E50E-4C48-88E2-849225976E96}" dt="2024-02-10T07:22:01.498" v="2635" actId="1038"/>
          <ac:spMkLst>
            <pc:docMk/>
            <pc:sldMk cId="294657801" sldId="290"/>
            <ac:spMk id="92" creationId="{71A157F5-1F6E-B01C-F573-F370548B03D5}"/>
          </ac:spMkLst>
        </pc:spChg>
        <pc:spChg chg="add mod">
          <ac:chgData name="勇治 箱崎" userId="9db2de78f3965622" providerId="LiveId" clId="{5B2AEB1F-E50E-4C48-88E2-849225976E96}" dt="2024-02-10T07:22:01.498" v="2635" actId="1038"/>
          <ac:spMkLst>
            <pc:docMk/>
            <pc:sldMk cId="294657801" sldId="290"/>
            <ac:spMk id="93" creationId="{E2D1AECC-005A-62E9-57E1-4F1374DD0C78}"/>
          </ac:spMkLst>
        </pc:spChg>
        <pc:spChg chg="add mod">
          <ac:chgData name="勇治 箱崎" userId="9db2de78f3965622" providerId="LiveId" clId="{5B2AEB1F-E50E-4C48-88E2-849225976E96}" dt="2024-02-10T07:22:01.498" v="2635" actId="1038"/>
          <ac:spMkLst>
            <pc:docMk/>
            <pc:sldMk cId="294657801" sldId="290"/>
            <ac:spMk id="94" creationId="{3A103167-5443-13DA-5532-CD56B4396D02}"/>
          </ac:spMkLst>
        </pc:spChg>
        <pc:spChg chg="add mod">
          <ac:chgData name="勇治 箱崎" userId="9db2de78f3965622" providerId="LiveId" clId="{5B2AEB1F-E50E-4C48-88E2-849225976E96}" dt="2024-02-10T07:27:28.651" v="2828" actId="1076"/>
          <ac:spMkLst>
            <pc:docMk/>
            <pc:sldMk cId="294657801" sldId="290"/>
            <ac:spMk id="99" creationId="{B06DC851-8CB9-B71E-7EFA-04FF2B740766}"/>
          </ac:spMkLst>
        </pc:spChg>
        <pc:spChg chg="add mod">
          <ac:chgData name="勇治 箱崎" userId="9db2de78f3965622" providerId="LiveId" clId="{5B2AEB1F-E50E-4C48-88E2-849225976E96}" dt="2024-02-10T07:46:44.795" v="3696" actId="1036"/>
          <ac:spMkLst>
            <pc:docMk/>
            <pc:sldMk cId="294657801" sldId="290"/>
            <ac:spMk id="102" creationId="{BDFCF825-531B-B957-F269-478F6760A18A}"/>
          </ac:spMkLst>
        </pc:spChg>
        <pc:spChg chg="add mod">
          <ac:chgData name="勇治 箱崎" userId="9db2de78f3965622" providerId="LiveId" clId="{5B2AEB1F-E50E-4C48-88E2-849225976E96}" dt="2024-02-10T07:35:29.638" v="3071" actId="1035"/>
          <ac:spMkLst>
            <pc:docMk/>
            <pc:sldMk cId="294657801" sldId="290"/>
            <ac:spMk id="103" creationId="{7A37C567-C6D9-40E4-F428-D7896FDB9849}"/>
          </ac:spMkLst>
        </pc:spChg>
        <pc:spChg chg="add mod">
          <ac:chgData name="勇治 箱崎" userId="9db2de78f3965622" providerId="LiveId" clId="{5B2AEB1F-E50E-4C48-88E2-849225976E96}" dt="2024-02-10T07:35:29.638" v="3071" actId="1035"/>
          <ac:spMkLst>
            <pc:docMk/>
            <pc:sldMk cId="294657801" sldId="290"/>
            <ac:spMk id="104" creationId="{6FFA4409-868F-D32B-4693-5FA265324F0C}"/>
          </ac:spMkLst>
        </pc:spChg>
        <pc:spChg chg="add mod">
          <ac:chgData name="勇治 箱崎" userId="9db2de78f3965622" providerId="LiveId" clId="{5B2AEB1F-E50E-4C48-88E2-849225976E96}" dt="2024-02-10T07:36:13.003" v="3077"/>
          <ac:spMkLst>
            <pc:docMk/>
            <pc:sldMk cId="294657801" sldId="290"/>
            <ac:spMk id="105" creationId="{FAD0C1B8-3EBE-F8A1-0C4B-C93C9424F4BA}"/>
          </ac:spMkLst>
        </pc:spChg>
        <pc:spChg chg="add mo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106" creationId="{EE3CAFE4-48E8-3CEA-E840-23D04406E337}"/>
          </ac:spMkLst>
        </pc:spChg>
        <pc:spChg chg="add mod or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107" creationId="{953A4B83-74C2-9D66-95A8-DBE796F5961D}"/>
          </ac:spMkLst>
        </pc:spChg>
        <pc:spChg chg="add mo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108" creationId="{CD150F47-4DF0-74EB-842F-A4C960396CED}"/>
          </ac:spMkLst>
        </pc:spChg>
        <pc:spChg chg="add mod">
          <ac:chgData name="勇治 箱崎" userId="9db2de78f3965622" providerId="LiveId" clId="{5B2AEB1F-E50E-4C48-88E2-849225976E96}" dt="2024-02-10T07:43:39.908" v="3573" actId="1076"/>
          <ac:spMkLst>
            <pc:docMk/>
            <pc:sldMk cId="294657801" sldId="290"/>
            <ac:spMk id="109" creationId="{DFE9EAE2-458D-F827-A684-24EE57B536B6}"/>
          </ac:spMkLst>
        </pc:spChg>
        <pc:spChg chg="add mod">
          <ac:chgData name="勇治 箱崎" userId="9db2de78f3965622" providerId="LiveId" clId="{5B2AEB1F-E50E-4C48-88E2-849225976E96}" dt="2024-02-10T07:41:24.219" v="3379" actId="20577"/>
          <ac:spMkLst>
            <pc:docMk/>
            <pc:sldMk cId="294657801" sldId="290"/>
            <ac:spMk id="110" creationId="{7F2476FE-5DD8-3930-4A40-C53BB858CBB1}"/>
          </ac:spMkLst>
        </pc:spChg>
        <pc:spChg chg="add del mod">
          <ac:chgData name="勇治 箱崎" userId="9db2de78f3965622" providerId="LiveId" clId="{5B2AEB1F-E50E-4C48-88E2-849225976E96}" dt="2024-02-10T07:39:27.102" v="3283" actId="478"/>
          <ac:spMkLst>
            <pc:docMk/>
            <pc:sldMk cId="294657801" sldId="290"/>
            <ac:spMk id="111" creationId="{3869EFC5-DA12-7646-F06E-89C3BD335201}"/>
          </ac:spMkLst>
        </pc:spChg>
        <pc:spChg chg="add mod">
          <ac:chgData name="勇治 箱崎" userId="9db2de78f3965622" providerId="LiveId" clId="{5B2AEB1F-E50E-4C48-88E2-849225976E96}" dt="2024-02-10T07:39:44.200" v="3285" actId="1076"/>
          <ac:spMkLst>
            <pc:docMk/>
            <pc:sldMk cId="294657801" sldId="290"/>
            <ac:spMk id="112" creationId="{FE04AA3A-47E6-E855-A7AD-06B72C3C5D66}"/>
          </ac:spMkLst>
        </pc:spChg>
        <pc:spChg chg="add del mod">
          <ac:chgData name="勇治 箱崎" userId="9db2de78f3965622" providerId="LiveId" clId="{5B2AEB1F-E50E-4C48-88E2-849225976E96}" dt="2024-02-10T07:36:34.232" v="3081" actId="478"/>
          <ac:spMkLst>
            <pc:docMk/>
            <pc:sldMk cId="294657801" sldId="290"/>
            <ac:spMk id="113" creationId="{3F563A56-E4C4-7467-4070-AF702BFDBCF1}"/>
          </ac:spMkLst>
        </pc:spChg>
        <pc:spChg chg="add mod">
          <ac:chgData name="勇治 箱崎" userId="9db2de78f3965622" providerId="LiveId" clId="{5B2AEB1F-E50E-4C48-88E2-849225976E96}" dt="2024-02-10T07:39:21.142" v="3282" actId="1035"/>
          <ac:spMkLst>
            <pc:docMk/>
            <pc:sldMk cId="294657801" sldId="290"/>
            <ac:spMk id="116" creationId="{889473DC-39ED-3C35-0042-AB01EC0EB548}"/>
          </ac:spMkLst>
        </pc:spChg>
        <pc:spChg chg="add mod">
          <ac:chgData name="勇治 箱崎" userId="9db2de78f3965622" providerId="LiveId" clId="{5B2AEB1F-E50E-4C48-88E2-849225976E96}" dt="2024-02-10T07:43:15.606" v="3564" actId="1038"/>
          <ac:spMkLst>
            <pc:docMk/>
            <pc:sldMk cId="294657801" sldId="290"/>
            <ac:spMk id="117" creationId="{8392D6E6-CADF-4715-476D-EAEE87A19D1A}"/>
          </ac:spMkLst>
        </pc:spChg>
        <pc:spChg chg="add del mod">
          <ac:chgData name="勇治 箱崎" userId="9db2de78f3965622" providerId="LiveId" clId="{5B2AEB1F-E50E-4C48-88E2-849225976E96}" dt="2024-02-10T07:42:28.460" v="3518" actId="478"/>
          <ac:spMkLst>
            <pc:docMk/>
            <pc:sldMk cId="294657801" sldId="290"/>
            <ac:spMk id="118" creationId="{B912CC0E-6B92-5856-D5FB-50D549DB359C}"/>
          </ac:spMkLst>
        </pc:spChg>
        <pc:spChg chg="add mod">
          <ac:chgData name="勇治 箱崎" userId="9db2de78f3965622" providerId="LiveId" clId="{5B2AEB1F-E50E-4C48-88E2-849225976E96}" dt="2024-02-10T07:46:44.795" v="3696" actId="1036"/>
          <ac:spMkLst>
            <pc:docMk/>
            <pc:sldMk cId="294657801" sldId="290"/>
            <ac:spMk id="119" creationId="{AFA3C960-CE23-8D55-E956-08583456905C}"/>
          </ac:spMkLst>
        </pc:spChg>
        <pc:spChg chg="add mod">
          <ac:chgData name="勇治 箱崎" userId="9db2de78f3965622" providerId="LiveId" clId="{5B2AEB1F-E50E-4C48-88E2-849225976E96}" dt="2024-02-10T07:43:15.606" v="3564" actId="1038"/>
          <ac:spMkLst>
            <pc:docMk/>
            <pc:sldMk cId="294657801" sldId="290"/>
            <ac:spMk id="120" creationId="{62792BF7-37DA-A8A4-86B9-4CD0F0A48919}"/>
          </ac:spMkLst>
        </pc:spChg>
        <pc:spChg chg="add mod">
          <ac:chgData name="勇治 箱崎" userId="9db2de78f3965622" providerId="LiveId" clId="{5B2AEB1F-E50E-4C48-88E2-849225976E96}" dt="2024-02-10T07:43:15.606" v="3564" actId="1038"/>
          <ac:spMkLst>
            <pc:docMk/>
            <pc:sldMk cId="294657801" sldId="290"/>
            <ac:spMk id="121" creationId="{6F1BA378-D815-8746-A54B-481DD75001E1}"/>
          </ac:spMkLst>
        </pc:spChg>
        <pc:spChg chg="add mod">
          <ac:chgData name="勇治 箱崎" userId="9db2de78f3965622" providerId="LiveId" clId="{5B2AEB1F-E50E-4C48-88E2-849225976E96}" dt="2024-02-10T07:43:15.606" v="3564" actId="1038"/>
          <ac:spMkLst>
            <pc:docMk/>
            <pc:sldMk cId="294657801" sldId="290"/>
            <ac:spMk id="122" creationId="{C605CDFF-9F0C-3585-F8F9-212EC78A1D35}"/>
          </ac:spMkLst>
        </pc:spChg>
        <pc:spChg chg="add mo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123" creationId="{B9E7C7C9-B5D3-5C76-1BE7-9C00222B9923}"/>
          </ac:spMkLst>
        </pc:spChg>
        <pc:spChg chg="add mod or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124" creationId="{4EF43213-D977-1554-BAAB-6A1A06C3EDA0}"/>
          </ac:spMkLst>
        </pc:spChg>
        <pc:spChg chg="add mod">
          <ac:chgData name="勇治 箱崎" userId="9db2de78f3965622" providerId="LiveId" clId="{5B2AEB1F-E50E-4C48-88E2-849225976E96}" dt="2024-02-10T07:56:36.345" v="3759" actId="1038"/>
          <ac:spMkLst>
            <pc:docMk/>
            <pc:sldMk cId="294657801" sldId="290"/>
            <ac:spMk id="125" creationId="{F56D96D0-C64C-9722-97CA-7737A9E64829}"/>
          </ac:spMkLst>
        </pc:spChg>
        <pc:spChg chg="add mod">
          <ac:chgData name="勇治 箱崎" userId="9db2de78f3965622" providerId="LiveId" clId="{5B2AEB1F-E50E-4C48-88E2-849225976E96}" dt="2024-02-10T07:45:49.708" v="3691" actId="20577"/>
          <ac:spMkLst>
            <pc:docMk/>
            <pc:sldMk cId="294657801" sldId="290"/>
            <ac:spMk id="126" creationId="{20C35D00-6E3F-A7CC-5909-A0A27A2A434E}"/>
          </ac:spMkLst>
        </pc:spChg>
        <pc:spChg chg="add mod">
          <ac:chgData name="勇治 箱崎" userId="9db2de78f3965622" providerId="LiveId" clId="{5B2AEB1F-E50E-4C48-88E2-849225976E96}" dt="2024-02-10T07:45:07.055" v="3641" actId="1037"/>
          <ac:spMkLst>
            <pc:docMk/>
            <pc:sldMk cId="294657801" sldId="290"/>
            <ac:spMk id="127" creationId="{B1A401A0-F871-B825-6AF3-68EF3CF0C368}"/>
          </ac:spMkLst>
        </pc:spChg>
        <pc:spChg chg="add mod">
          <ac:chgData name="勇治 箱崎" userId="9db2de78f3965622" providerId="LiveId" clId="{5B2AEB1F-E50E-4C48-88E2-849225976E96}" dt="2024-02-10T07:43:15.606" v="3564" actId="1038"/>
          <ac:spMkLst>
            <pc:docMk/>
            <pc:sldMk cId="294657801" sldId="290"/>
            <ac:spMk id="128" creationId="{995D3BD7-8357-0878-97FF-2D6AC49ECFEC}"/>
          </ac:spMkLst>
        </pc:spChg>
        <pc:picChg chg="del">
          <ac:chgData name="勇治 箱崎" userId="9db2de78f3965622" providerId="LiveId" clId="{5B2AEB1F-E50E-4C48-88E2-849225976E96}" dt="2024-02-10T06:57:52.280" v="1763" actId="478"/>
          <ac:picMkLst>
            <pc:docMk/>
            <pc:sldMk cId="294657801" sldId="290"/>
            <ac:picMk id="5" creationId="{479897AB-FBC7-3532-41C3-87913F1A26FB}"/>
          </ac:picMkLst>
        </pc:picChg>
        <pc:picChg chg="add del mod ord modCrop">
          <ac:chgData name="勇治 箱崎" userId="9db2de78f3965622" providerId="LiveId" clId="{5B2AEB1F-E50E-4C48-88E2-849225976E96}" dt="2024-02-10T07:06:18.834" v="2056" actId="478"/>
          <ac:picMkLst>
            <pc:docMk/>
            <pc:sldMk cId="294657801" sldId="290"/>
            <ac:picMk id="10" creationId="{A25BF10F-3C74-FF7C-65E8-ADB7CBA012C4}"/>
          </ac:picMkLst>
        </pc:picChg>
        <pc:picChg chg="del">
          <ac:chgData name="勇治 箱崎" userId="9db2de78f3965622" providerId="LiveId" clId="{5B2AEB1F-E50E-4C48-88E2-849225976E96}" dt="2024-02-10T06:57:35.127" v="1699" actId="478"/>
          <ac:picMkLst>
            <pc:docMk/>
            <pc:sldMk cId="294657801" sldId="290"/>
            <ac:picMk id="31" creationId="{17CC6C5C-A723-10BC-58BE-3CDBC1BF2E1E}"/>
          </ac:picMkLst>
        </pc:picChg>
        <pc:picChg chg="del">
          <ac:chgData name="勇治 箱崎" userId="9db2de78f3965622" providerId="LiveId" clId="{5B2AEB1F-E50E-4C48-88E2-849225976E96}" dt="2024-02-10T06:58:38.620" v="1947" actId="478"/>
          <ac:picMkLst>
            <pc:docMk/>
            <pc:sldMk cId="294657801" sldId="290"/>
            <ac:picMk id="49" creationId="{1E385CFE-3914-F179-630E-BC88B060E5D6}"/>
          </ac:picMkLst>
        </pc:picChg>
        <pc:picChg chg="del">
          <ac:chgData name="勇治 箱崎" userId="9db2de78f3965622" providerId="LiveId" clId="{5B2AEB1F-E50E-4C48-88E2-849225976E96}" dt="2024-02-10T06:58:39.917" v="1949" actId="478"/>
          <ac:picMkLst>
            <pc:docMk/>
            <pc:sldMk cId="294657801" sldId="290"/>
            <ac:picMk id="64" creationId="{26A0B19E-68B6-3E23-A206-F4D8CD5F3E40}"/>
          </ac:picMkLst>
        </pc:picChg>
        <pc:picChg chg="add del mod ord modCrop">
          <ac:chgData name="勇治 箱崎" userId="9db2de78f3965622" providerId="LiveId" clId="{5B2AEB1F-E50E-4C48-88E2-849225976E96}" dt="2024-02-10T07:09:54.176" v="2115" actId="478"/>
          <ac:picMkLst>
            <pc:docMk/>
            <pc:sldMk cId="294657801" sldId="290"/>
            <ac:picMk id="66" creationId="{1AC7FA59-D1EF-DB00-6078-C79A61703589}"/>
          </ac:picMkLst>
        </pc:picChg>
        <pc:picChg chg="add mod ord modCrop">
          <ac:chgData name="勇治 箱崎" userId="9db2de78f3965622" providerId="LiveId" clId="{5B2AEB1F-E50E-4C48-88E2-849225976E96}" dt="2024-02-10T07:12:53.342" v="2174" actId="1036"/>
          <ac:picMkLst>
            <pc:docMk/>
            <pc:sldMk cId="294657801" sldId="290"/>
            <ac:picMk id="68" creationId="{868F0F82-427A-A2A8-F0B2-D38E0AB29DBE}"/>
          </ac:picMkLst>
        </pc:picChg>
        <pc:picChg chg="add del mod ord modCrop">
          <ac:chgData name="勇治 箱崎" userId="9db2de78f3965622" providerId="LiveId" clId="{5B2AEB1F-E50E-4C48-88E2-849225976E96}" dt="2024-02-10T07:24:29.956" v="2776" actId="478"/>
          <ac:picMkLst>
            <pc:docMk/>
            <pc:sldMk cId="294657801" sldId="290"/>
            <ac:picMk id="70" creationId="{33EC380C-361D-CD65-8DFA-9EED44C046CB}"/>
          </ac:picMkLst>
        </pc:picChg>
        <pc:picChg chg="add mod">
          <ac:chgData name="勇治 箱崎" userId="9db2de78f3965622" providerId="LiveId" clId="{5B2AEB1F-E50E-4C48-88E2-849225976E96}" dt="2024-02-10T07:21:42.265" v="2495"/>
          <ac:picMkLst>
            <pc:docMk/>
            <pc:sldMk cId="294657801" sldId="290"/>
            <ac:picMk id="71" creationId="{557E82E6-E5CC-DE2E-3EFD-F0ECF0DC6676}"/>
          </ac:picMkLst>
        </pc:picChg>
        <pc:picChg chg="add del mod ord modCrop">
          <ac:chgData name="勇治 箱崎" userId="9db2de78f3965622" providerId="LiveId" clId="{5B2AEB1F-E50E-4C48-88E2-849225976E96}" dt="2024-02-10T07:26:02.287" v="2799" actId="478"/>
          <ac:picMkLst>
            <pc:docMk/>
            <pc:sldMk cId="294657801" sldId="290"/>
            <ac:picMk id="96" creationId="{811123A2-BF7A-C0F0-38D3-9E8E2C7500EB}"/>
          </ac:picMkLst>
        </pc:picChg>
        <pc:picChg chg="add mod ord modCrop">
          <ac:chgData name="勇治 箱崎" userId="9db2de78f3965622" providerId="LiveId" clId="{5B2AEB1F-E50E-4C48-88E2-849225976E96}" dt="2024-02-10T07:44:05.318" v="3576" actId="167"/>
          <ac:picMkLst>
            <pc:docMk/>
            <pc:sldMk cId="294657801" sldId="290"/>
            <ac:picMk id="98" creationId="{52D51C16-C50F-95FA-B4EF-68C6E78BD231}"/>
          </ac:picMkLst>
        </pc:picChg>
        <pc:picChg chg="add mod ord modCrop">
          <ac:chgData name="勇治 箱崎" userId="9db2de78f3965622" providerId="LiveId" clId="{5B2AEB1F-E50E-4C48-88E2-849225976E96}" dt="2024-02-10T07:47:00.732" v="3698" actId="1035"/>
          <ac:picMkLst>
            <pc:docMk/>
            <pc:sldMk cId="294657801" sldId="290"/>
            <ac:picMk id="101" creationId="{5C7504D0-5FA1-3751-67BB-F897CC86B816}"/>
          </ac:picMkLst>
        </pc:picChg>
        <pc:picChg chg="add mod ord modCrop">
          <ac:chgData name="勇治 箱崎" userId="9db2de78f3965622" providerId="LiveId" clId="{5B2AEB1F-E50E-4C48-88E2-849225976E96}" dt="2024-02-10T07:46:57.992" v="3697" actId="1035"/>
          <ac:picMkLst>
            <pc:docMk/>
            <pc:sldMk cId="294657801" sldId="290"/>
            <ac:picMk id="115" creationId="{93847BF6-D66B-0FA5-57A0-347A66E236AC}"/>
          </ac:picMkLst>
        </pc:picChg>
      </pc:sldChg>
      <pc:sldChg chg="addSp delSp modSp mod">
        <pc:chgData name="勇治 箱崎" userId="9db2de78f3965622" providerId="LiveId" clId="{5B2AEB1F-E50E-4C48-88E2-849225976E96}" dt="2024-02-10T06:56:01.917" v="1687" actId="478"/>
        <pc:sldMkLst>
          <pc:docMk/>
          <pc:sldMk cId="1816511275" sldId="291"/>
        </pc:sldMkLst>
        <pc:spChg chg="mod">
          <ac:chgData name="勇治 箱崎" userId="9db2de78f3965622" providerId="LiveId" clId="{5B2AEB1F-E50E-4C48-88E2-849225976E96}" dt="2024-02-10T06:49:35.206" v="1250" actId="1038"/>
          <ac:spMkLst>
            <pc:docMk/>
            <pc:sldMk cId="1816511275" sldId="291"/>
            <ac:spMk id="2" creationId="{437971F0-504B-51F1-DF09-9F137684466C}"/>
          </ac:spMkLst>
        </pc:spChg>
        <pc:spChg chg="mod">
          <ac:chgData name="勇治 箱崎" userId="9db2de78f3965622" providerId="LiveId" clId="{5B2AEB1F-E50E-4C48-88E2-849225976E96}" dt="2024-02-10T06:51:02.424" v="1325" actId="1037"/>
          <ac:spMkLst>
            <pc:docMk/>
            <pc:sldMk cId="1816511275" sldId="291"/>
            <ac:spMk id="5" creationId="{CABFF369-6918-A2D6-5AA3-20E52E2ABDC5}"/>
          </ac:spMkLst>
        </pc:spChg>
        <pc:spChg chg="del mod">
          <ac:chgData name="勇治 箱崎" userId="9db2de78f3965622" providerId="LiveId" clId="{5B2AEB1F-E50E-4C48-88E2-849225976E96}" dt="2024-02-10T05:39:56.714" v="711" actId="478"/>
          <ac:spMkLst>
            <pc:docMk/>
            <pc:sldMk cId="1816511275" sldId="291"/>
            <ac:spMk id="6" creationId="{1AF52245-216A-DAA8-7F69-0CF09B8C7D90}"/>
          </ac:spMkLst>
        </pc:spChg>
        <pc:spChg chg="del mod">
          <ac:chgData name="勇治 箱崎" userId="9db2de78f3965622" providerId="LiveId" clId="{5B2AEB1F-E50E-4C48-88E2-849225976E96}" dt="2024-02-10T06:45:42.667" v="1037" actId="478"/>
          <ac:spMkLst>
            <pc:docMk/>
            <pc:sldMk cId="1816511275" sldId="291"/>
            <ac:spMk id="7" creationId="{F4E90B46-3232-E6F8-90E9-5E44CDCC317F}"/>
          </ac:spMkLst>
        </pc:spChg>
        <pc:spChg chg="mod">
          <ac:chgData name="勇治 箱崎" userId="9db2de78f3965622" providerId="LiveId" clId="{5B2AEB1F-E50E-4C48-88E2-849225976E96}" dt="2024-02-10T06:51:45.060" v="1348" actId="1037"/>
          <ac:spMkLst>
            <pc:docMk/>
            <pc:sldMk cId="1816511275" sldId="291"/>
            <ac:spMk id="9" creationId="{87CB3CD2-099B-AC27-BD8C-78E17A3BC9B7}"/>
          </ac:spMkLst>
        </pc:spChg>
        <pc:spChg chg="mod">
          <ac:chgData name="勇治 箱崎" userId="9db2de78f3965622" providerId="LiveId" clId="{5B2AEB1F-E50E-4C48-88E2-849225976E96}" dt="2024-02-10T06:47:33.119" v="1088" actId="1038"/>
          <ac:spMkLst>
            <pc:docMk/>
            <pc:sldMk cId="1816511275" sldId="291"/>
            <ac:spMk id="10" creationId="{2D3ED657-A994-F257-FA55-CC51F2B955B6}"/>
          </ac:spMkLst>
        </pc:spChg>
        <pc:spChg chg="mod">
          <ac:chgData name="勇治 箱崎" userId="9db2de78f3965622" providerId="LiveId" clId="{5B2AEB1F-E50E-4C48-88E2-849225976E96}" dt="2024-02-10T05:42:00.115" v="792" actId="1036"/>
          <ac:spMkLst>
            <pc:docMk/>
            <pc:sldMk cId="1816511275" sldId="291"/>
            <ac:spMk id="11" creationId="{5553F4C3-68E9-4F89-F2A2-1D29173A8C04}"/>
          </ac:spMkLst>
        </pc:spChg>
        <pc:spChg chg="mod">
          <ac:chgData name="勇治 箱崎" userId="9db2de78f3965622" providerId="LiveId" clId="{5B2AEB1F-E50E-4C48-88E2-849225976E96}" dt="2024-02-10T05:46:18.367" v="865" actId="1076"/>
          <ac:spMkLst>
            <pc:docMk/>
            <pc:sldMk cId="1816511275" sldId="291"/>
            <ac:spMk id="13" creationId="{C6083EE7-D4D0-0A55-0B2B-E607D32AB25D}"/>
          </ac:spMkLst>
        </pc:spChg>
        <pc:spChg chg="add mod">
          <ac:chgData name="勇治 箱崎" userId="9db2de78f3965622" providerId="LiveId" clId="{5B2AEB1F-E50E-4C48-88E2-849225976E96}" dt="2024-02-10T05:31:48.988" v="490" actId="1076"/>
          <ac:spMkLst>
            <pc:docMk/>
            <pc:sldMk cId="1816511275" sldId="291"/>
            <ac:spMk id="21" creationId="{12F4A69B-3E6B-3B1D-71CA-CD9CAF2BD3CC}"/>
          </ac:spMkLst>
        </pc:spChg>
        <pc:spChg chg="add mod">
          <ac:chgData name="勇治 箱崎" userId="9db2de78f3965622" providerId="LiveId" clId="{5B2AEB1F-E50E-4C48-88E2-849225976E96}" dt="2024-02-10T05:31:48.988" v="490" actId="1076"/>
          <ac:spMkLst>
            <pc:docMk/>
            <pc:sldMk cId="1816511275" sldId="291"/>
            <ac:spMk id="22" creationId="{4F9C4AAE-F907-092B-DAB4-999931F68207}"/>
          </ac:spMkLst>
        </pc:spChg>
        <pc:spChg chg="del mod">
          <ac:chgData name="勇治 箱崎" userId="9db2de78f3965622" providerId="LiveId" clId="{5B2AEB1F-E50E-4C48-88E2-849225976E96}" dt="2024-02-10T05:39:53.973" v="710" actId="478"/>
          <ac:spMkLst>
            <pc:docMk/>
            <pc:sldMk cId="1816511275" sldId="291"/>
            <ac:spMk id="23" creationId="{E4EE78F3-6A6B-F1F0-F693-8677538F8942}"/>
          </ac:spMkLst>
        </pc:spChg>
        <pc:spChg chg="del mod">
          <ac:chgData name="勇治 箱崎" userId="9db2de78f3965622" providerId="LiveId" clId="{5B2AEB1F-E50E-4C48-88E2-849225976E96}" dt="2024-02-10T05:39:52.531" v="709" actId="478"/>
          <ac:spMkLst>
            <pc:docMk/>
            <pc:sldMk cId="1816511275" sldId="291"/>
            <ac:spMk id="24" creationId="{08880ACF-7061-B4BB-B4D5-A9E1834FC18D}"/>
          </ac:spMkLst>
        </pc:spChg>
        <pc:spChg chg="add mod">
          <ac:chgData name="勇治 箱崎" userId="9db2de78f3965622" providerId="LiveId" clId="{5B2AEB1F-E50E-4C48-88E2-849225976E96}" dt="2024-02-10T05:31:48.988" v="490" actId="1076"/>
          <ac:spMkLst>
            <pc:docMk/>
            <pc:sldMk cId="1816511275" sldId="291"/>
            <ac:spMk id="25" creationId="{1EEDBB84-878A-BAA2-6E27-5E7FABE99224}"/>
          </ac:spMkLst>
        </pc:spChg>
        <pc:spChg chg="add mod">
          <ac:chgData name="勇治 箱崎" userId="9db2de78f3965622" providerId="LiveId" clId="{5B2AEB1F-E50E-4C48-88E2-849225976E96}" dt="2024-02-10T05:31:48.988" v="490" actId="1076"/>
          <ac:spMkLst>
            <pc:docMk/>
            <pc:sldMk cId="1816511275" sldId="291"/>
            <ac:spMk id="26" creationId="{B1E1F284-48B9-4D81-8F63-A8A1D9F09D20}"/>
          </ac:spMkLst>
        </pc:spChg>
        <pc:spChg chg="add mod">
          <ac:chgData name="勇治 箱崎" userId="9db2de78f3965622" providerId="LiveId" clId="{5B2AEB1F-E50E-4C48-88E2-849225976E96}" dt="2024-02-10T05:31:48.988" v="490" actId="1076"/>
          <ac:spMkLst>
            <pc:docMk/>
            <pc:sldMk cId="1816511275" sldId="291"/>
            <ac:spMk id="27" creationId="{A8C2C676-5092-D1DF-05A0-8BEC1C5F8ABD}"/>
          </ac:spMkLst>
        </pc:spChg>
        <pc:spChg chg="add mod">
          <ac:chgData name="勇治 箱崎" userId="9db2de78f3965622" providerId="LiveId" clId="{5B2AEB1F-E50E-4C48-88E2-849225976E96}" dt="2024-02-10T05:31:48.988" v="490" actId="1076"/>
          <ac:spMkLst>
            <pc:docMk/>
            <pc:sldMk cId="1816511275" sldId="291"/>
            <ac:spMk id="28" creationId="{40D521D2-78CA-4883-E357-D9C0C64560C9}"/>
          </ac:spMkLst>
        </pc:spChg>
        <pc:spChg chg="add mod">
          <ac:chgData name="勇治 箱崎" userId="9db2de78f3965622" providerId="LiveId" clId="{5B2AEB1F-E50E-4C48-88E2-849225976E96}" dt="2024-02-10T05:31:48.988" v="490" actId="1076"/>
          <ac:spMkLst>
            <pc:docMk/>
            <pc:sldMk cId="1816511275" sldId="291"/>
            <ac:spMk id="29" creationId="{1C02B234-26E4-1B35-5155-7DC85C45801E}"/>
          </ac:spMkLst>
        </pc:spChg>
        <pc:spChg chg="add mod">
          <ac:chgData name="勇治 箱崎" userId="9db2de78f3965622" providerId="LiveId" clId="{5B2AEB1F-E50E-4C48-88E2-849225976E96}" dt="2024-02-10T05:31:48.988" v="490" actId="1076"/>
          <ac:spMkLst>
            <pc:docMk/>
            <pc:sldMk cId="1816511275" sldId="291"/>
            <ac:spMk id="30" creationId="{F04CCDE5-A869-343E-2263-CC6BF28B42F5}"/>
          </ac:spMkLst>
        </pc:spChg>
        <pc:spChg chg="add mod">
          <ac:chgData name="勇治 箱崎" userId="9db2de78f3965622" providerId="LiveId" clId="{5B2AEB1F-E50E-4C48-88E2-849225976E96}" dt="2024-02-10T05:31:48.988" v="490" actId="1076"/>
          <ac:spMkLst>
            <pc:docMk/>
            <pc:sldMk cId="1816511275" sldId="291"/>
            <ac:spMk id="31" creationId="{41769E8F-0185-D6BB-A758-7270BF329DD7}"/>
          </ac:spMkLst>
        </pc:spChg>
        <pc:spChg chg="add mod">
          <ac:chgData name="勇治 箱崎" userId="9db2de78f3965622" providerId="LiveId" clId="{5B2AEB1F-E50E-4C48-88E2-849225976E96}" dt="2024-02-10T06:50:00.652" v="1270" actId="1036"/>
          <ac:spMkLst>
            <pc:docMk/>
            <pc:sldMk cId="1816511275" sldId="291"/>
            <ac:spMk id="32" creationId="{146A8630-E9ED-AFCE-7FE8-F1A6003E67D3}"/>
          </ac:spMkLst>
        </pc:spChg>
        <pc:spChg chg="add del mod">
          <ac:chgData name="勇治 箱崎" userId="9db2de78f3965622" providerId="LiveId" clId="{5B2AEB1F-E50E-4C48-88E2-849225976E96}" dt="2024-02-10T05:45:52.640" v="845" actId="478"/>
          <ac:spMkLst>
            <pc:docMk/>
            <pc:sldMk cId="1816511275" sldId="291"/>
            <ac:spMk id="33" creationId="{3346F6AE-76F3-95E5-E1B7-11EEDE06A132}"/>
          </ac:spMkLst>
        </pc:spChg>
        <pc:spChg chg="add mod">
          <ac:chgData name="勇治 箱崎" userId="9db2de78f3965622" providerId="LiveId" clId="{5B2AEB1F-E50E-4C48-88E2-849225976E96}" dt="2024-02-10T05:42:08.330" v="810" actId="1036"/>
          <ac:spMkLst>
            <pc:docMk/>
            <pc:sldMk cId="1816511275" sldId="291"/>
            <ac:spMk id="34" creationId="{01925CB9-A77B-10DE-6633-ACC765522A48}"/>
          </ac:spMkLst>
        </pc:spChg>
        <pc:spChg chg="mod">
          <ac:chgData name="勇治 箱崎" userId="9db2de78f3965622" providerId="LiveId" clId="{5B2AEB1F-E50E-4C48-88E2-849225976E96}" dt="2024-02-10T05:42:00.115" v="792" actId="1036"/>
          <ac:spMkLst>
            <pc:docMk/>
            <pc:sldMk cId="1816511275" sldId="291"/>
            <ac:spMk id="37" creationId="{D1E6E47D-74FD-F38D-FA38-5EB5DCBE1519}"/>
          </ac:spMkLst>
        </pc:spChg>
        <pc:spChg chg="add mod">
          <ac:chgData name="勇治 箱崎" userId="9db2de78f3965622" providerId="LiveId" clId="{5B2AEB1F-E50E-4C48-88E2-849225976E96}" dt="2024-02-10T05:45:55.591" v="857" actId="1035"/>
          <ac:spMkLst>
            <pc:docMk/>
            <pc:sldMk cId="1816511275" sldId="291"/>
            <ac:spMk id="38" creationId="{49063DC4-7A42-B494-07A2-FDF7E1A3585D}"/>
          </ac:spMkLst>
        </pc:spChg>
        <pc:spChg chg="add mod ord">
          <ac:chgData name="勇治 箱崎" userId="9db2de78f3965622" providerId="LiveId" clId="{5B2AEB1F-E50E-4C48-88E2-849225976E96}" dt="2024-02-10T06:52:17.133" v="1366" actId="20577"/>
          <ac:spMkLst>
            <pc:docMk/>
            <pc:sldMk cId="1816511275" sldId="291"/>
            <ac:spMk id="39" creationId="{1C5CEF82-6E21-D849-7D10-2C5E31300C88}"/>
          </ac:spMkLst>
        </pc:spChg>
        <pc:spChg chg="add mod">
          <ac:chgData name="勇治 箱崎" userId="9db2de78f3965622" providerId="LiveId" clId="{5B2AEB1F-E50E-4C48-88E2-849225976E96}" dt="2024-02-10T06:49:38.948" v="1252" actId="20577"/>
          <ac:spMkLst>
            <pc:docMk/>
            <pc:sldMk cId="1816511275" sldId="291"/>
            <ac:spMk id="42" creationId="{61398A7E-B006-A073-B2C7-A9B1DDD4CB28}"/>
          </ac:spMkLst>
        </pc:spChg>
        <pc:spChg chg="add del mod">
          <ac:chgData name="勇治 箱崎" userId="9db2de78f3965622" providerId="LiveId" clId="{5B2AEB1F-E50E-4C48-88E2-849225976E96}" dt="2024-02-10T06:51:12.718" v="1327" actId="478"/>
          <ac:spMkLst>
            <pc:docMk/>
            <pc:sldMk cId="1816511275" sldId="291"/>
            <ac:spMk id="43" creationId="{6A7FFA5E-8FD2-4FEF-E720-6F9EE3B64E44}"/>
          </ac:spMkLst>
        </pc:spChg>
        <pc:spChg chg="add mod">
          <ac:chgData name="勇治 箱崎" userId="9db2de78f3965622" providerId="LiveId" clId="{5B2AEB1F-E50E-4C48-88E2-849225976E96}" dt="2024-02-10T06:51:02.424" v="1325" actId="1037"/>
          <ac:spMkLst>
            <pc:docMk/>
            <pc:sldMk cId="1816511275" sldId="291"/>
            <ac:spMk id="44" creationId="{5F978025-9400-D92F-4C41-55E925C3E21C}"/>
          </ac:spMkLst>
        </pc:spChg>
        <pc:spChg chg="add mod">
          <ac:chgData name="勇治 箱崎" userId="9db2de78f3965622" providerId="LiveId" clId="{5B2AEB1F-E50E-4C48-88E2-849225976E96}" dt="2024-02-10T06:52:52.075" v="1519" actId="1037"/>
          <ac:spMkLst>
            <pc:docMk/>
            <pc:sldMk cId="1816511275" sldId="291"/>
            <ac:spMk id="45" creationId="{83D1B59C-2759-801C-2F5F-38C49FBEFE2C}"/>
          </ac:spMkLst>
        </pc:spChg>
        <pc:spChg chg="add mod">
          <ac:chgData name="勇治 箱崎" userId="9db2de78f3965622" providerId="LiveId" clId="{5B2AEB1F-E50E-4C48-88E2-849225976E96}" dt="2024-02-10T06:50:24.514" v="1301" actId="20577"/>
          <ac:spMkLst>
            <pc:docMk/>
            <pc:sldMk cId="1816511275" sldId="291"/>
            <ac:spMk id="46" creationId="{AA485C4B-21A7-A616-B650-C931A605E952}"/>
          </ac:spMkLst>
        </pc:spChg>
        <pc:spChg chg="add mod">
          <ac:chgData name="勇治 箱崎" userId="9db2de78f3965622" providerId="LiveId" clId="{5B2AEB1F-E50E-4C48-88E2-849225976E96}" dt="2024-02-10T06:49:24.720" v="1237" actId="1037"/>
          <ac:spMkLst>
            <pc:docMk/>
            <pc:sldMk cId="1816511275" sldId="291"/>
            <ac:spMk id="47" creationId="{39137A10-9E9F-C766-326D-C561EA518945}"/>
          </ac:spMkLst>
        </pc:spChg>
        <pc:spChg chg="add mod">
          <ac:chgData name="勇治 箱崎" userId="9db2de78f3965622" providerId="LiveId" clId="{5B2AEB1F-E50E-4C48-88E2-849225976E96}" dt="2024-02-10T06:50:30.428" v="1303" actId="20577"/>
          <ac:spMkLst>
            <pc:docMk/>
            <pc:sldMk cId="1816511275" sldId="291"/>
            <ac:spMk id="48" creationId="{43A7EC99-2A19-B2B7-CF69-77425A5400CF}"/>
          </ac:spMkLst>
        </pc:spChg>
        <pc:spChg chg="add mod">
          <ac:chgData name="勇治 箱崎" userId="9db2de78f3965622" providerId="LiveId" clId="{5B2AEB1F-E50E-4C48-88E2-849225976E96}" dt="2024-02-10T06:49:24.720" v="1237" actId="1037"/>
          <ac:spMkLst>
            <pc:docMk/>
            <pc:sldMk cId="1816511275" sldId="291"/>
            <ac:spMk id="49" creationId="{1F21C942-9722-B44A-907F-81AB86BE76BC}"/>
          </ac:spMkLst>
        </pc:spChg>
        <pc:spChg chg="add mod">
          <ac:chgData name="勇治 箱崎" userId="9db2de78f3965622" providerId="LiveId" clId="{5B2AEB1F-E50E-4C48-88E2-849225976E96}" dt="2024-02-10T06:50:06.376" v="1271" actId="1037"/>
          <ac:spMkLst>
            <pc:docMk/>
            <pc:sldMk cId="1816511275" sldId="291"/>
            <ac:spMk id="50" creationId="{7E992887-FDE2-881D-FA7C-902E8FDB907E}"/>
          </ac:spMkLst>
        </pc:spChg>
        <pc:spChg chg="del mod">
          <ac:chgData name="勇治 箱崎" userId="9db2de78f3965622" providerId="LiveId" clId="{5B2AEB1F-E50E-4C48-88E2-849225976E96}" dt="2024-02-10T06:49:42.826" v="1253" actId="478"/>
          <ac:spMkLst>
            <pc:docMk/>
            <pc:sldMk cId="1816511275" sldId="291"/>
            <ac:spMk id="52" creationId="{F0D30E17-3134-3BED-EB3D-C9BDCDB94D65}"/>
          </ac:spMkLst>
        </pc:spChg>
        <pc:spChg chg="del mod">
          <ac:chgData name="勇治 箱崎" userId="9db2de78f3965622" providerId="LiveId" clId="{5B2AEB1F-E50E-4C48-88E2-849225976E96}" dt="2024-02-10T06:51:07.164" v="1326" actId="478"/>
          <ac:spMkLst>
            <pc:docMk/>
            <pc:sldMk cId="1816511275" sldId="291"/>
            <ac:spMk id="53" creationId="{27E121AC-78BF-74E6-0DE6-A60BE7CCD666}"/>
          </ac:spMkLst>
        </pc:spChg>
        <pc:spChg chg="mod">
          <ac:chgData name="勇治 箱崎" userId="9db2de78f3965622" providerId="LiveId" clId="{5B2AEB1F-E50E-4C48-88E2-849225976E96}" dt="2024-02-10T04:53:35.080" v="317" actId="1076"/>
          <ac:spMkLst>
            <pc:docMk/>
            <pc:sldMk cId="1816511275" sldId="291"/>
            <ac:spMk id="54" creationId="{8F2D5E89-1274-0564-0218-7A8EAAF44F27}"/>
          </ac:spMkLst>
        </pc:spChg>
        <pc:spChg chg="del mod">
          <ac:chgData name="勇治 箱崎" userId="9db2de78f3965622" providerId="LiveId" clId="{5B2AEB1F-E50E-4C48-88E2-849225976E96}" dt="2024-02-10T06:54:47.946" v="1600" actId="478"/>
          <ac:spMkLst>
            <pc:docMk/>
            <pc:sldMk cId="1816511275" sldId="291"/>
            <ac:spMk id="55" creationId="{BCA741DF-68AD-BF0E-0A0B-6BC33113D5C2}"/>
          </ac:spMkLst>
        </pc:spChg>
        <pc:spChg chg="del mod">
          <ac:chgData name="勇治 箱崎" userId="9db2de78f3965622" providerId="LiveId" clId="{5B2AEB1F-E50E-4C48-88E2-849225976E96}" dt="2024-02-10T06:54:03.097" v="1560" actId="478"/>
          <ac:spMkLst>
            <pc:docMk/>
            <pc:sldMk cId="1816511275" sldId="291"/>
            <ac:spMk id="56" creationId="{EE64FBB7-7236-3E6A-1955-8F8E00514FAC}"/>
          </ac:spMkLst>
        </pc:spChg>
        <pc:spChg chg="del mod">
          <ac:chgData name="勇治 箱崎" userId="9db2de78f3965622" providerId="LiveId" clId="{5B2AEB1F-E50E-4C48-88E2-849225976E96}" dt="2024-02-10T06:56:01.917" v="1687" actId="478"/>
          <ac:spMkLst>
            <pc:docMk/>
            <pc:sldMk cId="1816511275" sldId="291"/>
            <ac:spMk id="57" creationId="{25E76791-55A8-1E38-5DEB-05DDFE82D1E1}"/>
          </ac:spMkLst>
        </pc:spChg>
        <pc:spChg chg="del mod">
          <ac:chgData name="勇治 箱崎" userId="9db2de78f3965622" providerId="LiveId" clId="{5B2AEB1F-E50E-4C48-88E2-849225976E96}" dt="2024-02-10T06:54:45.238" v="1599" actId="478"/>
          <ac:spMkLst>
            <pc:docMk/>
            <pc:sldMk cId="1816511275" sldId="291"/>
            <ac:spMk id="58" creationId="{341CACE4-B604-FCC6-50BD-FC0A40489B4B}"/>
          </ac:spMkLst>
        </pc:spChg>
        <pc:spChg chg="mod">
          <ac:chgData name="勇治 箱崎" userId="9db2de78f3965622" providerId="LiveId" clId="{5B2AEB1F-E50E-4C48-88E2-849225976E96}" dt="2024-02-10T04:53:35.080" v="317" actId="1076"/>
          <ac:spMkLst>
            <pc:docMk/>
            <pc:sldMk cId="1816511275" sldId="291"/>
            <ac:spMk id="59" creationId="{7F5905B4-0641-B13E-6A66-E783494BF5EA}"/>
          </ac:spMkLst>
        </pc:spChg>
        <pc:spChg chg="del mod">
          <ac:chgData name="勇治 箱崎" userId="9db2de78f3965622" providerId="LiveId" clId="{5B2AEB1F-E50E-4C48-88E2-849225976E96}" dt="2024-02-10T06:50:40.237" v="1305" actId="478"/>
          <ac:spMkLst>
            <pc:docMk/>
            <pc:sldMk cId="1816511275" sldId="291"/>
            <ac:spMk id="60" creationId="{530B06E7-9927-8C06-2C1C-49C1FB1D2C34}"/>
          </ac:spMkLst>
        </pc:spChg>
        <pc:spChg chg="del mod">
          <ac:chgData name="勇治 箱崎" userId="9db2de78f3965622" providerId="LiveId" clId="{5B2AEB1F-E50E-4C48-88E2-849225976E96}" dt="2024-02-10T06:48:58.513" v="1106" actId="478"/>
          <ac:spMkLst>
            <pc:docMk/>
            <pc:sldMk cId="1816511275" sldId="291"/>
            <ac:spMk id="61" creationId="{8B85BC08-4959-6B46-DF8E-C46DB521AC4E}"/>
          </ac:spMkLst>
        </pc:spChg>
        <pc:spChg chg="del mod">
          <ac:chgData name="勇治 箱崎" userId="9db2de78f3965622" providerId="LiveId" clId="{5B2AEB1F-E50E-4C48-88E2-849225976E96}" dt="2024-02-10T06:48:58.513" v="1106" actId="478"/>
          <ac:spMkLst>
            <pc:docMk/>
            <pc:sldMk cId="1816511275" sldId="291"/>
            <ac:spMk id="62" creationId="{2E0FD2B5-9B0D-22D9-C085-5E8D4FE1F9D8}"/>
          </ac:spMkLst>
        </pc:spChg>
        <pc:spChg chg="mod">
          <ac:chgData name="勇治 箱崎" userId="9db2de78f3965622" providerId="LiveId" clId="{5B2AEB1F-E50E-4C48-88E2-849225976E96}" dt="2024-02-10T04:53:35.080" v="317" actId="1076"/>
          <ac:spMkLst>
            <pc:docMk/>
            <pc:sldMk cId="1816511275" sldId="291"/>
            <ac:spMk id="63" creationId="{5B409333-4B91-47FF-520E-F62D8EC123F3}"/>
          </ac:spMkLst>
        </pc:spChg>
        <pc:spChg chg="mod">
          <ac:chgData name="勇治 箱崎" userId="9db2de78f3965622" providerId="LiveId" clId="{5B2AEB1F-E50E-4C48-88E2-849225976E96}" dt="2024-02-10T04:53:35.080" v="317" actId="1076"/>
          <ac:spMkLst>
            <pc:docMk/>
            <pc:sldMk cId="1816511275" sldId="291"/>
            <ac:spMk id="64" creationId="{9682A2AA-6B3E-65F7-D9DC-2923A8AC0B89}"/>
          </ac:spMkLst>
        </pc:spChg>
        <pc:spChg chg="add mod">
          <ac:chgData name="勇治 箱崎" userId="9db2de78f3965622" providerId="LiveId" clId="{5B2AEB1F-E50E-4C48-88E2-849225976E96}" dt="2024-02-10T06:49:24.720" v="1237" actId="1037"/>
          <ac:spMkLst>
            <pc:docMk/>
            <pc:sldMk cId="1816511275" sldId="291"/>
            <ac:spMk id="65" creationId="{4B1CA3B1-4239-62B4-7A69-1CA543E056CC}"/>
          </ac:spMkLst>
        </pc:spChg>
        <pc:spChg chg="add mod">
          <ac:chgData name="勇治 箱崎" userId="9db2de78f3965622" providerId="LiveId" clId="{5B2AEB1F-E50E-4C48-88E2-849225976E96}" dt="2024-02-10T06:49:24.720" v="1237" actId="1037"/>
          <ac:spMkLst>
            <pc:docMk/>
            <pc:sldMk cId="1816511275" sldId="291"/>
            <ac:spMk id="66" creationId="{FDE94AE8-04CB-303F-DC8C-096AC84B0579}"/>
          </ac:spMkLst>
        </pc:spChg>
        <pc:spChg chg="add del mod ord">
          <ac:chgData name="勇治 箱崎" userId="9db2de78f3965622" providerId="LiveId" clId="{5B2AEB1F-E50E-4C48-88E2-849225976E96}" dt="2024-02-10T06:52:25.381" v="1367" actId="478"/>
          <ac:spMkLst>
            <pc:docMk/>
            <pc:sldMk cId="1816511275" sldId="291"/>
            <ac:spMk id="67" creationId="{DEAD4929-D4BB-7A82-453B-3FB7D6686000}"/>
          </ac:spMkLst>
        </pc:spChg>
        <pc:spChg chg="add mod">
          <ac:chgData name="勇治 箱崎" userId="9db2de78f3965622" providerId="LiveId" clId="{5B2AEB1F-E50E-4C48-88E2-849225976E96}" dt="2024-02-10T06:55:56.608" v="1685" actId="20577"/>
          <ac:spMkLst>
            <pc:docMk/>
            <pc:sldMk cId="1816511275" sldId="291"/>
            <ac:spMk id="68" creationId="{B7680B77-4C18-A8FD-0821-287E6797784C}"/>
          </ac:spMkLst>
        </pc:spChg>
        <pc:picChg chg="del mod">
          <ac:chgData name="勇治 箱崎" userId="9db2de78f3965622" providerId="LiveId" clId="{5B2AEB1F-E50E-4C48-88E2-849225976E96}" dt="2024-02-10T04:55:10.711" v="328" actId="478"/>
          <ac:picMkLst>
            <pc:docMk/>
            <pc:sldMk cId="1816511275" sldId="291"/>
            <ac:picMk id="4" creationId="{73685857-0992-357B-2420-D3FAD36204F7}"/>
          </ac:picMkLst>
        </pc:picChg>
        <pc:picChg chg="add del mod modCrop">
          <ac:chgData name="勇治 箱崎" userId="9db2de78f3965622" providerId="LiveId" clId="{5B2AEB1F-E50E-4C48-88E2-849225976E96}" dt="2024-02-10T04:57:55.326" v="397" actId="478"/>
          <ac:picMkLst>
            <pc:docMk/>
            <pc:sldMk cId="1816511275" sldId="291"/>
            <ac:picMk id="12" creationId="{6B374B71-9115-465B-EE30-A268860CF35F}"/>
          </ac:picMkLst>
        </pc:picChg>
        <pc:picChg chg="add del mod ord modCrop">
          <ac:chgData name="勇治 箱崎" userId="9db2de78f3965622" providerId="LiveId" clId="{5B2AEB1F-E50E-4C48-88E2-849225976E96}" dt="2024-02-10T05:41:12.145" v="723" actId="478"/>
          <ac:picMkLst>
            <pc:docMk/>
            <pc:sldMk cId="1816511275" sldId="291"/>
            <ac:picMk id="15" creationId="{9BB477CB-91EB-F2CC-A50A-8F1AD5FCF97E}"/>
          </ac:picMkLst>
        </pc:picChg>
        <pc:picChg chg="add del mod modCrop">
          <ac:chgData name="勇治 箱崎" userId="9db2de78f3965622" providerId="LiveId" clId="{5B2AEB1F-E50E-4C48-88E2-849225976E96}" dt="2024-02-10T05:07:39.715" v="438" actId="478"/>
          <ac:picMkLst>
            <pc:docMk/>
            <pc:sldMk cId="1816511275" sldId="291"/>
            <ac:picMk id="17" creationId="{71BD19EB-77EE-CB1E-CD1B-67B73C40CAE8}"/>
          </ac:picMkLst>
        </pc:picChg>
        <pc:picChg chg="add del mod modCrop">
          <ac:chgData name="勇治 箱崎" userId="9db2de78f3965622" providerId="LiveId" clId="{5B2AEB1F-E50E-4C48-88E2-849225976E96}" dt="2024-02-10T06:48:49.387" v="1102" actId="478"/>
          <ac:picMkLst>
            <pc:docMk/>
            <pc:sldMk cId="1816511275" sldId="291"/>
            <ac:picMk id="19" creationId="{A8FCA759-DD8B-52B7-16BB-5EBFB3552092}"/>
          </ac:picMkLst>
        </pc:picChg>
        <pc:picChg chg="add mod">
          <ac:chgData name="勇治 箱崎" userId="9db2de78f3965622" providerId="LiveId" clId="{5B2AEB1F-E50E-4C48-88E2-849225976E96}" dt="2024-02-10T05:31:48.988" v="490" actId="1076"/>
          <ac:picMkLst>
            <pc:docMk/>
            <pc:sldMk cId="1816511275" sldId="291"/>
            <ac:picMk id="20" creationId="{A5045FCE-577A-7B57-D4C0-D7ACD4FCF98B}"/>
          </ac:picMkLst>
        </pc:picChg>
        <pc:picChg chg="add mod ord modCrop">
          <ac:chgData name="勇治 箱崎" userId="9db2de78f3965622" providerId="LiveId" clId="{5B2AEB1F-E50E-4C48-88E2-849225976E96}" dt="2024-02-10T06:47:39.792" v="1091" actId="1037"/>
          <ac:picMkLst>
            <pc:docMk/>
            <pc:sldMk cId="1816511275" sldId="291"/>
            <ac:picMk id="36" creationId="{B8F91A6F-F488-55C4-C255-CEACEEF58A8D}"/>
          </ac:picMkLst>
        </pc:picChg>
        <pc:picChg chg="add mod modCrop">
          <ac:chgData name="勇治 箱崎" userId="9db2de78f3965622" providerId="LiveId" clId="{5B2AEB1F-E50E-4C48-88E2-849225976E96}" dt="2024-02-10T06:53:51.268" v="1559" actId="14100"/>
          <ac:picMkLst>
            <pc:docMk/>
            <pc:sldMk cId="1816511275" sldId="291"/>
            <ac:picMk id="41" creationId="{C56C1382-EE92-751A-5388-0D8E3B3D1B3E}"/>
          </ac:picMkLst>
        </pc:picChg>
        <pc:picChg chg="del mod">
          <ac:chgData name="勇治 箱崎" userId="9db2de78f3965622" providerId="LiveId" clId="{5B2AEB1F-E50E-4C48-88E2-849225976E96}" dt="2024-02-10T05:08:08.357" v="446" actId="478"/>
          <ac:picMkLst>
            <pc:docMk/>
            <pc:sldMk cId="1816511275" sldId="291"/>
            <ac:picMk id="51" creationId="{25948B8F-F385-0F40-98EA-5EB70793EB24}"/>
          </ac:picMkLst>
        </pc:picChg>
      </pc:sldChg>
    </pc:docChg>
  </pc:docChgLst>
  <pc:docChgLst>
    <pc:chgData name="勇治 箱崎" userId="9db2de78f3965622" providerId="LiveId" clId="{F3BAA24D-41A6-4CB4-9001-F8C01AF06D58}"/>
    <pc:docChg chg="undo custSel modSld">
      <pc:chgData name="勇治 箱崎" userId="9db2de78f3965622" providerId="LiveId" clId="{F3BAA24D-41A6-4CB4-9001-F8C01AF06D58}" dt="2024-03-07T00:36:57.915" v="18" actId="1076"/>
      <pc:docMkLst>
        <pc:docMk/>
      </pc:docMkLst>
      <pc:sldChg chg="modSp mod">
        <pc:chgData name="勇治 箱崎" userId="9db2de78f3965622" providerId="LiveId" clId="{F3BAA24D-41A6-4CB4-9001-F8C01AF06D58}" dt="2024-03-07T00:36:57.915" v="18" actId="1076"/>
        <pc:sldMkLst>
          <pc:docMk/>
          <pc:sldMk cId="594557811" sldId="261"/>
        </pc:sldMkLst>
        <pc:spChg chg="mod">
          <ac:chgData name="勇治 箱崎" userId="9db2de78f3965622" providerId="LiveId" clId="{F3BAA24D-41A6-4CB4-9001-F8C01AF06D58}" dt="2024-03-07T00:36:29.501" v="7" actId="1582"/>
          <ac:spMkLst>
            <pc:docMk/>
            <pc:sldMk cId="594557811" sldId="261"/>
            <ac:spMk id="4" creationId="{F72996F6-B3A8-DF26-553D-39C7A3057DFC}"/>
          </ac:spMkLst>
        </pc:spChg>
        <pc:spChg chg="mod">
          <ac:chgData name="勇治 箱崎" userId="9db2de78f3965622" providerId="LiveId" clId="{F3BAA24D-41A6-4CB4-9001-F8C01AF06D58}" dt="2024-03-07T00:36:42.779" v="14" actId="1076"/>
          <ac:spMkLst>
            <pc:docMk/>
            <pc:sldMk cId="594557811" sldId="261"/>
            <ac:spMk id="5" creationId="{D60418FF-2B74-D24E-A029-596AD1DF1674}"/>
          </ac:spMkLst>
        </pc:spChg>
        <pc:spChg chg="mod">
          <ac:chgData name="勇治 箱崎" userId="9db2de78f3965622" providerId="LiveId" clId="{F3BAA24D-41A6-4CB4-9001-F8C01AF06D58}" dt="2024-03-07T00:36:55.020" v="17" actId="1076"/>
          <ac:spMkLst>
            <pc:docMk/>
            <pc:sldMk cId="594557811" sldId="261"/>
            <ac:spMk id="6" creationId="{9AF4AD90-19AC-96A6-A44C-F04CD4BC9E99}"/>
          </ac:spMkLst>
        </pc:spChg>
        <pc:spChg chg="mod">
          <ac:chgData name="勇治 箱崎" userId="9db2de78f3965622" providerId="LiveId" clId="{F3BAA24D-41A6-4CB4-9001-F8C01AF06D58}" dt="2024-03-07T00:36:57.915" v="18" actId="1076"/>
          <ac:spMkLst>
            <pc:docMk/>
            <pc:sldMk cId="594557811" sldId="261"/>
            <ac:spMk id="7" creationId="{EB2F6B53-CA76-0FF5-D87C-C177295D864E}"/>
          </ac:spMkLst>
        </pc:spChg>
        <pc:spChg chg="mod">
          <ac:chgData name="勇治 箱崎" userId="9db2de78f3965622" providerId="LiveId" clId="{F3BAA24D-41A6-4CB4-9001-F8C01AF06D58}" dt="2024-03-07T00:36:50.717" v="16" actId="1076"/>
          <ac:spMkLst>
            <pc:docMk/>
            <pc:sldMk cId="594557811" sldId="261"/>
            <ac:spMk id="8" creationId="{70B17266-449F-7D18-B0ED-3C9167F0BB78}"/>
          </ac:spMkLst>
        </pc:spChg>
        <pc:spChg chg="mod">
          <ac:chgData name="勇治 箱崎" userId="9db2de78f3965622" providerId="LiveId" clId="{F3BAA24D-41A6-4CB4-9001-F8C01AF06D58}" dt="2024-03-07T00:36:09.624" v="3" actId="255"/>
          <ac:spMkLst>
            <pc:docMk/>
            <pc:sldMk cId="594557811" sldId="261"/>
            <ac:spMk id="10" creationId="{6630DD00-102E-4220-8380-7079E3054576}"/>
          </ac:spMkLst>
        </pc:spChg>
      </pc:sldChg>
      <pc:sldChg chg="modSp mod">
        <pc:chgData name="勇治 箱崎" userId="9db2de78f3965622" providerId="LiveId" clId="{F3BAA24D-41A6-4CB4-9001-F8C01AF06D58}" dt="2024-03-07T00:35:56.886" v="1" actId="14100"/>
        <pc:sldMkLst>
          <pc:docMk/>
          <pc:sldMk cId="3562092320" sldId="262"/>
        </pc:sldMkLst>
        <pc:spChg chg="mod">
          <ac:chgData name="勇治 箱崎" userId="9db2de78f3965622" providerId="LiveId" clId="{F3BAA24D-41A6-4CB4-9001-F8C01AF06D58}" dt="2024-03-07T00:35:56.886" v="1" actId="14100"/>
          <ac:spMkLst>
            <pc:docMk/>
            <pc:sldMk cId="3562092320" sldId="262"/>
            <ac:spMk id="8" creationId="{9A2B45F9-8C57-D29C-2FEC-5A837548CECE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1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8275A6-89D6-4ED8-A655-E3C94C36500F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855788" y="1233488"/>
            <a:ext cx="302418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9691"/>
            <a:ext cx="5388610" cy="388611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4301"/>
            <a:ext cx="2918831" cy="4951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FF1860-DE20-482A-A67D-C519290DA6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5257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1pPr>
    <a:lvl2pPr marL="457164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2pPr>
    <a:lvl3pPr marL="914329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3pPr>
    <a:lvl4pPr marL="1371493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4pPr>
    <a:lvl5pPr marL="1828656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5pPr>
    <a:lvl6pPr marL="2285821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6pPr>
    <a:lvl7pPr marL="2742985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7pPr>
    <a:lvl8pPr marL="3200150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8pPr>
    <a:lvl9pPr marL="3657314" algn="l" defTabSz="914329" rtl="0" eaLnBrk="1" latinLnBrk="0" hangingPunct="1">
      <a:defRPr kumimoji="1" sz="120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7082" y="1122363"/>
            <a:ext cx="5293599" cy="2387600"/>
          </a:xfrm>
        </p:spPr>
        <p:txBody>
          <a:bodyPr anchor="b"/>
          <a:lstStyle>
            <a:lvl1pPr algn="ctr">
              <a:defRPr sz="4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78471" y="3602038"/>
            <a:ext cx="4670822" cy="1655762"/>
          </a:xfrm>
        </p:spPr>
        <p:txBody>
          <a:bodyPr/>
          <a:lstStyle>
            <a:lvl1pPr marL="0" indent="0" algn="ctr">
              <a:buNone/>
              <a:defRPr sz="1635"/>
            </a:lvl1pPr>
            <a:lvl2pPr marL="311399" indent="0" algn="ctr">
              <a:buNone/>
              <a:defRPr sz="1362"/>
            </a:lvl2pPr>
            <a:lvl3pPr marL="622798" indent="0" algn="ctr">
              <a:buNone/>
              <a:defRPr sz="1226"/>
            </a:lvl3pPr>
            <a:lvl4pPr marL="934197" indent="0" algn="ctr">
              <a:buNone/>
              <a:defRPr sz="1090"/>
            </a:lvl4pPr>
            <a:lvl5pPr marL="1245596" indent="0" algn="ctr">
              <a:buNone/>
              <a:defRPr sz="1090"/>
            </a:lvl5pPr>
            <a:lvl6pPr marL="1556995" indent="0" algn="ctr">
              <a:buNone/>
              <a:defRPr sz="1090"/>
            </a:lvl6pPr>
            <a:lvl7pPr marL="1868394" indent="0" algn="ctr">
              <a:buNone/>
              <a:defRPr sz="1090"/>
            </a:lvl7pPr>
            <a:lvl8pPr marL="2179792" indent="0" algn="ctr">
              <a:buNone/>
              <a:defRPr sz="1090"/>
            </a:lvl8pPr>
            <a:lvl9pPr marL="2491191" indent="0" algn="ctr">
              <a:buNone/>
              <a:defRPr sz="109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34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1966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56743" y="365125"/>
            <a:ext cx="134286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8159" y="365125"/>
            <a:ext cx="3950737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011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7909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4915" y="1709740"/>
            <a:ext cx="5371446" cy="2852737"/>
          </a:xfrm>
        </p:spPr>
        <p:txBody>
          <a:bodyPr anchor="b"/>
          <a:lstStyle>
            <a:lvl1pPr>
              <a:defRPr sz="408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4915" y="4589465"/>
            <a:ext cx="5371446" cy="1500187"/>
          </a:xfrm>
        </p:spPr>
        <p:txBody>
          <a:bodyPr/>
          <a:lstStyle>
            <a:lvl1pPr marL="0" indent="0">
              <a:buNone/>
              <a:defRPr sz="1635">
                <a:solidFill>
                  <a:schemeClr val="tx1"/>
                </a:solidFill>
              </a:defRPr>
            </a:lvl1pPr>
            <a:lvl2pPr marL="311399" indent="0">
              <a:buNone/>
              <a:defRPr sz="1362">
                <a:solidFill>
                  <a:schemeClr val="tx1">
                    <a:tint val="75000"/>
                  </a:schemeClr>
                </a:solidFill>
              </a:defRPr>
            </a:lvl2pPr>
            <a:lvl3pPr marL="622798" indent="0">
              <a:buNone/>
              <a:defRPr sz="1226">
                <a:solidFill>
                  <a:schemeClr val="tx1">
                    <a:tint val="75000"/>
                  </a:schemeClr>
                </a:solidFill>
              </a:defRPr>
            </a:lvl3pPr>
            <a:lvl4pPr marL="934197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4pPr>
            <a:lvl5pPr marL="1245596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5pPr>
            <a:lvl6pPr marL="1556995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6pPr>
            <a:lvl7pPr marL="1868394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7pPr>
            <a:lvl8pPr marL="2179792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8pPr>
            <a:lvl9pPr marL="2491191" indent="0">
              <a:buNone/>
              <a:defRPr sz="10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908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8159" y="1825625"/>
            <a:ext cx="2646799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52805" y="1825625"/>
            <a:ext cx="2646799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311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365127"/>
            <a:ext cx="5371446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971" y="1681163"/>
            <a:ext cx="2634635" cy="823912"/>
          </a:xfrm>
        </p:spPr>
        <p:txBody>
          <a:bodyPr anchor="b"/>
          <a:lstStyle>
            <a:lvl1pPr marL="0" indent="0">
              <a:buNone/>
              <a:defRPr sz="1635" b="1"/>
            </a:lvl1pPr>
            <a:lvl2pPr marL="311399" indent="0">
              <a:buNone/>
              <a:defRPr sz="1362" b="1"/>
            </a:lvl2pPr>
            <a:lvl3pPr marL="622798" indent="0">
              <a:buNone/>
              <a:defRPr sz="1226" b="1"/>
            </a:lvl3pPr>
            <a:lvl4pPr marL="934197" indent="0">
              <a:buNone/>
              <a:defRPr sz="1090" b="1"/>
            </a:lvl4pPr>
            <a:lvl5pPr marL="1245596" indent="0">
              <a:buNone/>
              <a:defRPr sz="1090" b="1"/>
            </a:lvl5pPr>
            <a:lvl6pPr marL="1556995" indent="0">
              <a:buNone/>
              <a:defRPr sz="1090" b="1"/>
            </a:lvl6pPr>
            <a:lvl7pPr marL="1868394" indent="0">
              <a:buNone/>
              <a:defRPr sz="1090" b="1"/>
            </a:lvl7pPr>
            <a:lvl8pPr marL="2179792" indent="0">
              <a:buNone/>
              <a:defRPr sz="1090" b="1"/>
            </a:lvl8pPr>
            <a:lvl9pPr marL="2491191" indent="0">
              <a:buNone/>
              <a:defRPr sz="10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8971" y="2505075"/>
            <a:ext cx="2634635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52806" y="1681163"/>
            <a:ext cx="2647610" cy="823912"/>
          </a:xfrm>
        </p:spPr>
        <p:txBody>
          <a:bodyPr anchor="b"/>
          <a:lstStyle>
            <a:lvl1pPr marL="0" indent="0">
              <a:buNone/>
              <a:defRPr sz="1635" b="1"/>
            </a:lvl1pPr>
            <a:lvl2pPr marL="311399" indent="0">
              <a:buNone/>
              <a:defRPr sz="1362" b="1"/>
            </a:lvl2pPr>
            <a:lvl3pPr marL="622798" indent="0">
              <a:buNone/>
              <a:defRPr sz="1226" b="1"/>
            </a:lvl3pPr>
            <a:lvl4pPr marL="934197" indent="0">
              <a:buNone/>
              <a:defRPr sz="1090" b="1"/>
            </a:lvl4pPr>
            <a:lvl5pPr marL="1245596" indent="0">
              <a:buNone/>
              <a:defRPr sz="1090" b="1"/>
            </a:lvl5pPr>
            <a:lvl6pPr marL="1556995" indent="0">
              <a:buNone/>
              <a:defRPr sz="1090" b="1"/>
            </a:lvl6pPr>
            <a:lvl7pPr marL="1868394" indent="0">
              <a:buNone/>
              <a:defRPr sz="1090" b="1"/>
            </a:lvl7pPr>
            <a:lvl8pPr marL="2179792" indent="0">
              <a:buNone/>
              <a:defRPr sz="1090" b="1"/>
            </a:lvl8pPr>
            <a:lvl9pPr marL="2491191" indent="0">
              <a:buNone/>
              <a:defRPr sz="109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52806" y="2505075"/>
            <a:ext cx="264761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30569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4263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2202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457200"/>
            <a:ext cx="2008616" cy="1600200"/>
          </a:xfrm>
        </p:spPr>
        <p:txBody>
          <a:bodyPr anchor="b"/>
          <a:lstStyle>
            <a:lvl1pPr>
              <a:defRPr sz="21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47610" y="987427"/>
            <a:ext cx="3152805" cy="4873625"/>
          </a:xfrm>
        </p:spPr>
        <p:txBody>
          <a:bodyPr/>
          <a:lstStyle>
            <a:lvl1pPr>
              <a:defRPr sz="2180"/>
            </a:lvl1pPr>
            <a:lvl2pPr>
              <a:defRPr sz="1907"/>
            </a:lvl2pPr>
            <a:lvl3pPr>
              <a:defRPr sz="1635"/>
            </a:lvl3pPr>
            <a:lvl4pPr>
              <a:defRPr sz="1362"/>
            </a:lvl4pPr>
            <a:lvl5pPr>
              <a:defRPr sz="1362"/>
            </a:lvl5pPr>
            <a:lvl6pPr>
              <a:defRPr sz="1362"/>
            </a:lvl6pPr>
            <a:lvl7pPr>
              <a:defRPr sz="1362"/>
            </a:lvl7pPr>
            <a:lvl8pPr>
              <a:defRPr sz="1362"/>
            </a:lvl8pPr>
            <a:lvl9pPr>
              <a:defRPr sz="136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057400"/>
            <a:ext cx="2008616" cy="3811588"/>
          </a:xfrm>
        </p:spPr>
        <p:txBody>
          <a:bodyPr/>
          <a:lstStyle>
            <a:lvl1pPr marL="0" indent="0">
              <a:buNone/>
              <a:defRPr sz="1090"/>
            </a:lvl1pPr>
            <a:lvl2pPr marL="311399" indent="0">
              <a:buNone/>
              <a:defRPr sz="954"/>
            </a:lvl2pPr>
            <a:lvl3pPr marL="622798" indent="0">
              <a:buNone/>
              <a:defRPr sz="817"/>
            </a:lvl3pPr>
            <a:lvl4pPr marL="934197" indent="0">
              <a:buNone/>
              <a:defRPr sz="681"/>
            </a:lvl4pPr>
            <a:lvl5pPr marL="1245596" indent="0">
              <a:buNone/>
              <a:defRPr sz="681"/>
            </a:lvl5pPr>
            <a:lvl6pPr marL="1556995" indent="0">
              <a:buNone/>
              <a:defRPr sz="681"/>
            </a:lvl6pPr>
            <a:lvl7pPr marL="1868394" indent="0">
              <a:buNone/>
              <a:defRPr sz="681"/>
            </a:lvl7pPr>
            <a:lvl8pPr marL="2179792" indent="0">
              <a:buNone/>
              <a:defRPr sz="681"/>
            </a:lvl8pPr>
            <a:lvl9pPr marL="2491191" indent="0">
              <a:buNone/>
              <a:defRPr sz="6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659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8970" y="457200"/>
            <a:ext cx="2008616" cy="1600200"/>
          </a:xfrm>
        </p:spPr>
        <p:txBody>
          <a:bodyPr anchor="b"/>
          <a:lstStyle>
            <a:lvl1pPr>
              <a:defRPr sz="218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47610" y="987427"/>
            <a:ext cx="3152805" cy="4873625"/>
          </a:xfrm>
        </p:spPr>
        <p:txBody>
          <a:bodyPr anchor="t"/>
          <a:lstStyle>
            <a:lvl1pPr marL="0" indent="0">
              <a:buNone/>
              <a:defRPr sz="2180"/>
            </a:lvl1pPr>
            <a:lvl2pPr marL="311399" indent="0">
              <a:buNone/>
              <a:defRPr sz="1907"/>
            </a:lvl2pPr>
            <a:lvl3pPr marL="622798" indent="0">
              <a:buNone/>
              <a:defRPr sz="1635"/>
            </a:lvl3pPr>
            <a:lvl4pPr marL="934197" indent="0">
              <a:buNone/>
              <a:defRPr sz="1362"/>
            </a:lvl4pPr>
            <a:lvl5pPr marL="1245596" indent="0">
              <a:buNone/>
              <a:defRPr sz="1362"/>
            </a:lvl5pPr>
            <a:lvl6pPr marL="1556995" indent="0">
              <a:buNone/>
              <a:defRPr sz="1362"/>
            </a:lvl6pPr>
            <a:lvl7pPr marL="1868394" indent="0">
              <a:buNone/>
              <a:defRPr sz="1362"/>
            </a:lvl7pPr>
            <a:lvl8pPr marL="2179792" indent="0">
              <a:buNone/>
              <a:defRPr sz="1362"/>
            </a:lvl8pPr>
            <a:lvl9pPr marL="2491191" indent="0">
              <a:buNone/>
              <a:defRPr sz="1362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8970" y="2057400"/>
            <a:ext cx="2008616" cy="3811588"/>
          </a:xfrm>
        </p:spPr>
        <p:txBody>
          <a:bodyPr/>
          <a:lstStyle>
            <a:lvl1pPr marL="0" indent="0">
              <a:buNone/>
              <a:defRPr sz="1090"/>
            </a:lvl1pPr>
            <a:lvl2pPr marL="311399" indent="0">
              <a:buNone/>
              <a:defRPr sz="954"/>
            </a:lvl2pPr>
            <a:lvl3pPr marL="622798" indent="0">
              <a:buNone/>
              <a:defRPr sz="817"/>
            </a:lvl3pPr>
            <a:lvl4pPr marL="934197" indent="0">
              <a:buNone/>
              <a:defRPr sz="681"/>
            </a:lvl4pPr>
            <a:lvl5pPr marL="1245596" indent="0">
              <a:buNone/>
              <a:defRPr sz="681"/>
            </a:lvl5pPr>
            <a:lvl6pPr marL="1556995" indent="0">
              <a:buNone/>
              <a:defRPr sz="681"/>
            </a:lvl6pPr>
            <a:lvl7pPr marL="1868394" indent="0">
              <a:buNone/>
              <a:defRPr sz="681"/>
            </a:lvl7pPr>
            <a:lvl8pPr marL="2179792" indent="0">
              <a:buNone/>
              <a:defRPr sz="681"/>
            </a:lvl8pPr>
            <a:lvl9pPr marL="2491191" indent="0">
              <a:buNone/>
              <a:defRPr sz="6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77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8159" y="365127"/>
            <a:ext cx="5371446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8159" y="1825625"/>
            <a:ext cx="5371446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8159" y="6356352"/>
            <a:ext cx="140124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3F134-369A-4EC9-9A1D-1D1677B45A0B}" type="datetimeFigureOut">
              <a:rPr kumimoji="1" lang="ja-JP" altLang="en-US" smtClean="0"/>
              <a:t>2024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62947" y="6356352"/>
            <a:ext cx="210187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98357" y="6356352"/>
            <a:ext cx="140124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B80FA9-EDF8-4057-AA62-8A51129B7DA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808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2798" rtl="0" eaLnBrk="1" latinLnBrk="0" hangingPunct="1">
        <a:lnSpc>
          <a:spcPct val="90000"/>
        </a:lnSpc>
        <a:spcBef>
          <a:spcPct val="0"/>
        </a:spcBef>
        <a:buNone/>
        <a:defRPr kumimoji="1" sz="29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5699" indent="-155699" algn="l" defTabSz="622798" rtl="0" eaLnBrk="1" latinLnBrk="0" hangingPunct="1">
        <a:lnSpc>
          <a:spcPct val="90000"/>
        </a:lnSpc>
        <a:spcBef>
          <a:spcPts val="681"/>
        </a:spcBef>
        <a:buFont typeface="Arial" panose="020B0604020202020204" pitchFamily="34" charset="0"/>
        <a:buChar char="•"/>
        <a:defRPr kumimoji="1" sz="1907" kern="1200">
          <a:solidFill>
            <a:schemeClr val="tx1"/>
          </a:solidFill>
          <a:latin typeface="+mn-lt"/>
          <a:ea typeface="+mn-ea"/>
          <a:cs typeface="+mn-cs"/>
        </a:defRPr>
      </a:lvl1pPr>
      <a:lvl2pPr marL="467098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635" kern="1200">
          <a:solidFill>
            <a:schemeClr val="tx1"/>
          </a:solidFill>
          <a:latin typeface="+mn-lt"/>
          <a:ea typeface="+mn-ea"/>
          <a:cs typeface="+mn-cs"/>
        </a:defRPr>
      </a:lvl2pPr>
      <a:lvl3pPr marL="778497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362" kern="1200">
          <a:solidFill>
            <a:schemeClr val="tx1"/>
          </a:solidFill>
          <a:latin typeface="+mn-lt"/>
          <a:ea typeface="+mn-ea"/>
          <a:cs typeface="+mn-cs"/>
        </a:defRPr>
      </a:lvl3pPr>
      <a:lvl4pPr marL="1089896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4pPr>
      <a:lvl5pPr marL="1401295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5pPr>
      <a:lvl6pPr marL="1712694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6pPr>
      <a:lvl7pPr marL="2024093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7pPr>
      <a:lvl8pPr marL="2335492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8pPr>
      <a:lvl9pPr marL="2646891" indent="-155699" algn="l" defTabSz="622798" rtl="0" eaLnBrk="1" latinLnBrk="0" hangingPunct="1">
        <a:lnSpc>
          <a:spcPct val="90000"/>
        </a:lnSpc>
        <a:spcBef>
          <a:spcPts val="341"/>
        </a:spcBef>
        <a:buFont typeface="Arial" panose="020B0604020202020204" pitchFamily="34" charset="0"/>
        <a:buChar char="•"/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1pPr>
      <a:lvl2pPr marL="311399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2pPr>
      <a:lvl3pPr marL="622798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3pPr>
      <a:lvl4pPr marL="934197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4pPr>
      <a:lvl5pPr marL="1245596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5pPr>
      <a:lvl6pPr marL="1556995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6pPr>
      <a:lvl7pPr marL="1868394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7pPr>
      <a:lvl8pPr marL="2179792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8pPr>
      <a:lvl9pPr marL="2491191" algn="l" defTabSz="622798" rtl="0" eaLnBrk="1" latinLnBrk="0" hangingPunct="1">
        <a:defRPr kumimoji="1" sz="12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72996F6-B3A8-DF26-553D-39C7A3057DFC}"/>
              </a:ext>
            </a:extLst>
          </p:cNvPr>
          <p:cNvSpPr txBox="1"/>
          <p:nvPr/>
        </p:nvSpPr>
        <p:spPr>
          <a:xfrm>
            <a:off x="86654" y="264703"/>
            <a:ext cx="1191352" cy="2154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9 consecutive patients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矢印: 下 4">
            <a:extLst>
              <a:ext uri="{FF2B5EF4-FFF2-40B4-BE49-F238E27FC236}">
                <a16:creationId xmlns:a16="http://schemas.microsoft.com/office/drawing/2014/main" id="{D60418FF-2B74-D24E-A029-596AD1DF1674}"/>
              </a:ext>
            </a:extLst>
          </p:cNvPr>
          <p:cNvSpPr/>
          <p:nvPr/>
        </p:nvSpPr>
        <p:spPr>
          <a:xfrm>
            <a:off x="312536" y="498957"/>
            <a:ext cx="101619" cy="649480"/>
          </a:xfrm>
          <a:prstGeom prst="downArrow">
            <a:avLst/>
          </a:prstGeom>
          <a:ln w="1905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6" name="矢印: 右 5">
            <a:extLst>
              <a:ext uri="{FF2B5EF4-FFF2-40B4-BE49-F238E27FC236}">
                <a16:creationId xmlns:a16="http://schemas.microsoft.com/office/drawing/2014/main" id="{9AF4AD90-19AC-96A6-A44C-F04CD4BC9E99}"/>
              </a:ext>
            </a:extLst>
          </p:cNvPr>
          <p:cNvSpPr/>
          <p:nvPr/>
        </p:nvSpPr>
        <p:spPr>
          <a:xfrm>
            <a:off x="363345" y="769697"/>
            <a:ext cx="395343" cy="108000"/>
          </a:xfrm>
          <a:prstGeom prst="rightArrow">
            <a:avLst/>
          </a:prstGeom>
          <a:ln w="1905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80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B2F6B53-CA76-0FF5-D87C-C177295D864E}"/>
              </a:ext>
            </a:extLst>
          </p:cNvPr>
          <p:cNvSpPr txBox="1"/>
          <p:nvPr/>
        </p:nvSpPr>
        <p:spPr>
          <a:xfrm>
            <a:off x="769854" y="592864"/>
            <a:ext cx="1624163" cy="46166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8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clusion criteria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story of inguinal hernia (N = 37)</a:t>
            </a:r>
          </a:p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 prevention (N = 2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0B17266-449F-7D18-B0ED-3C9167F0BB78}"/>
              </a:ext>
            </a:extLst>
          </p:cNvPr>
          <p:cNvSpPr txBox="1"/>
          <p:nvPr/>
        </p:nvSpPr>
        <p:spPr>
          <a:xfrm>
            <a:off x="86654" y="1194854"/>
            <a:ext cx="683200" cy="2154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0 patients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630DD00-102E-4220-8380-7079E3054576}"/>
              </a:ext>
            </a:extLst>
          </p:cNvPr>
          <p:cNvSpPr txBox="1"/>
          <p:nvPr/>
        </p:nvSpPr>
        <p:spPr>
          <a:xfrm>
            <a:off x="2109" y="5313"/>
            <a:ext cx="53855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1 Flowchart of inclusion and exclusion criteria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4557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456</TotalTime>
  <Words>33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箱崎 勇治</dc:creator>
  <cp:lastModifiedBy>Radhika Selvaraj</cp:lastModifiedBy>
  <cp:revision>122</cp:revision>
  <cp:lastPrinted>2024-02-05T05:57:24Z</cp:lastPrinted>
  <dcterms:created xsi:type="dcterms:W3CDTF">2023-04-05T09:48:44Z</dcterms:created>
  <dcterms:modified xsi:type="dcterms:W3CDTF">2024-07-06T01:54:45Z</dcterms:modified>
</cp:coreProperties>
</file>